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png" ContentType="image/png"/>
  <Override PartName="/ppt/media/image9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601200" cy="12801600"/>
  <p:notesSz cx="6872288" cy="100615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B074A-B3C5-4D7B-9B1F-A28FB3EE64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9520" y="2987640"/>
            <a:ext cx="864216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9520" y="7399800"/>
            <a:ext cx="864216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D02A09-7842-4236-BF94-A5CC8A3CBC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9520" y="298764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907880" y="298764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9520" y="739980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907880" y="739980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EA6B7-4E9C-436E-BCE4-4176AAAD67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9520" y="2987640"/>
            <a:ext cx="27824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401640" y="2987640"/>
            <a:ext cx="27824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323400" y="2987640"/>
            <a:ext cx="27824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9520" y="7399800"/>
            <a:ext cx="27824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401640" y="7399800"/>
            <a:ext cx="27824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323400" y="7399800"/>
            <a:ext cx="27824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41126-A7A2-4E9E-B334-C3AE9E67AD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9520" y="2987640"/>
            <a:ext cx="8642160" cy="844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25"/>
              </a:spcBef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5417A6-E6D7-40CE-8CDD-C5B25F2F66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9520" y="2987640"/>
            <a:ext cx="8642160" cy="84470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F6F65C-7C27-4BDB-A8C8-4029500F5E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9520" y="2987640"/>
            <a:ext cx="4217040" cy="84470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907880" y="2987640"/>
            <a:ext cx="4217040" cy="84470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CF54B-ABBF-4242-97D9-5796E8C762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5FDD3-0DB8-48BA-8AC4-5E84BBB5B0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9520" y="512280"/>
            <a:ext cx="8642160" cy="989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25"/>
              </a:spcBef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91743-7C70-4E81-A464-B19B7F74C7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9520" y="298764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907880" y="2987640"/>
            <a:ext cx="4217040" cy="84470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9520" y="739980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19CA5-4291-4CCA-94EE-DAFDAA4C28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9520" y="2987640"/>
            <a:ext cx="4217040" cy="84470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907880" y="298764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907880" y="739980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4FC0D-09A3-4E65-AD14-4DB0A1B1B5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9520" y="298764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907880" y="2987640"/>
            <a:ext cx="421704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9520" y="7399800"/>
            <a:ext cx="8642160" cy="40291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5143C-8064-49DA-B691-325A19B42D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9520" y="512280"/>
            <a:ext cx="8642160" cy="21337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9520" y="2987640"/>
            <a:ext cx="8642160" cy="84470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marL="479520" indent="-47952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  <a:p>
            <a:pPr lvl="1" marL="1039680" indent="-39996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  <a:p>
            <a:pPr lvl="2" marL="1600200" indent="-32076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  <a:p>
            <a:pPr lvl="3" marL="2239920" indent="-31896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  <a:p>
            <a:pPr lvl="4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  <a:p>
            <a:pPr lvl="5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  <a:p>
            <a:pPr lvl="6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9520" y="11656800"/>
            <a:ext cx="2241360" cy="8888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Autofit/>
          </a:bodyPr>
          <a:lstStyle>
            <a:lvl1pPr indent="0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  <a:defRPr b="0" lang="en-US" sz="2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79600" y="11656800"/>
            <a:ext cx="3042000" cy="8888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Autofit/>
          </a:bodyPr>
          <a:lstStyle>
            <a:lvl1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  <a:defRPr b="0" lang="en-US" sz="2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880320" y="11656800"/>
            <a:ext cx="2241360" cy="8888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Autofit/>
          </a:bodyPr>
          <a:lstStyle>
            <a:lvl1pPr indent="0" algn="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  <a:defRPr b="0" lang="en-US" sz="2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fld id="{6DE1375B-44E1-4B61-9E8F-C0C8C227F48F}" type="slidenum">
              <a:rPr b="0" lang="en-US" sz="2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png"/><Relationship Id="rId9" Type="http://schemas.openxmlformats.org/officeDocument/2006/relationships/image" Target="../media/image8.png"/><Relationship Id="rId10" Type="http://schemas.openxmlformats.org/officeDocument/2006/relationships/image" Target="../media/image8.png"/><Relationship Id="rId11" Type="http://schemas.openxmlformats.org/officeDocument/2006/relationships/image" Target="../media/image8.png"/><Relationship Id="rId12" Type="http://schemas.openxmlformats.org/officeDocument/2006/relationships/image" Target="../media/image8.png"/><Relationship Id="rId13" Type="http://schemas.openxmlformats.org/officeDocument/2006/relationships/image" Target="../media/image8.png"/><Relationship Id="rId14" Type="http://schemas.openxmlformats.org/officeDocument/2006/relationships/image" Target="../media/image8.png"/><Relationship Id="rId15" Type="http://schemas.openxmlformats.org/officeDocument/2006/relationships/image" Target="../media/image8.png"/><Relationship Id="rId16" Type="http://schemas.openxmlformats.org/officeDocument/2006/relationships/image" Target="../media/image8.png"/><Relationship Id="rId17" Type="http://schemas.openxmlformats.org/officeDocument/2006/relationships/image" Target="../media/image8.png"/><Relationship Id="rId18" Type="http://schemas.openxmlformats.org/officeDocument/2006/relationships/image" Target="../media/image8.png"/><Relationship Id="rId19" Type="http://schemas.openxmlformats.org/officeDocument/2006/relationships/image" Target="../media/image8.png"/><Relationship Id="rId20" Type="http://schemas.openxmlformats.org/officeDocument/2006/relationships/image" Target="../media/image8.png"/><Relationship Id="rId21" Type="http://schemas.openxmlformats.org/officeDocument/2006/relationships/image" Target="../media/image8.png"/><Relationship Id="rId22" Type="http://schemas.openxmlformats.org/officeDocument/2006/relationships/image" Target="../media/image8.png"/><Relationship Id="rId23" Type="http://schemas.openxmlformats.org/officeDocument/2006/relationships/image" Target="../media/image8.png"/><Relationship Id="rId24" Type="http://schemas.openxmlformats.org/officeDocument/2006/relationships/image" Target="../media/image8.png"/><Relationship Id="rId25" Type="http://schemas.openxmlformats.org/officeDocument/2006/relationships/image" Target="../media/image8.png"/><Relationship Id="rId26" Type="http://schemas.openxmlformats.org/officeDocument/2006/relationships/image" Target="../media/image8.png"/><Relationship Id="rId27" Type="http://schemas.openxmlformats.org/officeDocument/2006/relationships/image" Target="../media/image8.png"/><Relationship Id="rId28" Type="http://schemas.openxmlformats.org/officeDocument/2006/relationships/image" Target="../media/image8.png"/><Relationship Id="rId29" Type="http://schemas.openxmlformats.org/officeDocument/2006/relationships/image" Target="../media/image8.png"/><Relationship Id="rId30" Type="http://schemas.openxmlformats.org/officeDocument/2006/relationships/image" Target="../media/image8.png"/><Relationship Id="rId31" Type="http://schemas.openxmlformats.org/officeDocument/2006/relationships/image" Target="../media/image8.png"/><Relationship Id="rId32" Type="http://schemas.openxmlformats.org/officeDocument/2006/relationships/image" Target="../media/image8.png"/><Relationship Id="rId33" Type="http://schemas.openxmlformats.org/officeDocument/2006/relationships/image" Target="../media/image8.png"/><Relationship Id="rId34" Type="http://schemas.openxmlformats.org/officeDocument/2006/relationships/image" Target="../media/image8.png"/><Relationship Id="rId35" Type="http://schemas.openxmlformats.org/officeDocument/2006/relationships/image" Target="../media/image8.png"/><Relationship Id="rId36" Type="http://schemas.openxmlformats.org/officeDocument/2006/relationships/image" Target="../media/image8.png"/><Relationship Id="rId37" Type="http://schemas.openxmlformats.org/officeDocument/2006/relationships/image" Target="../media/image8.png"/><Relationship Id="rId38" Type="http://schemas.openxmlformats.org/officeDocument/2006/relationships/image" Target="../media/image8.png"/><Relationship Id="rId39" Type="http://schemas.openxmlformats.org/officeDocument/2006/relationships/image" Target="../media/image8.png"/><Relationship Id="rId40" Type="http://schemas.openxmlformats.org/officeDocument/2006/relationships/image" Target="../media/image8.png"/><Relationship Id="rId41" Type="http://schemas.openxmlformats.org/officeDocument/2006/relationships/image" Target="../media/image8.png"/><Relationship Id="rId42" Type="http://schemas.openxmlformats.org/officeDocument/2006/relationships/image" Target="../media/image8.png"/><Relationship Id="rId43" Type="http://schemas.openxmlformats.org/officeDocument/2006/relationships/image" Target="../media/image9.wmf"/><Relationship Id="rId44" Type="http://schemas.openxmlformats.org/officeDocument/2006/relationships/image" Target="../media/image9.wmf"/><Relationship Id="rId45" Type="http://schemas.openxmlformats.org/officeDocument/2006/relationships/image" Target="../media/image8.png"/><Relationship Id="rId46" Type="http://schemas.openxmlformats.org/officeDocument/2006/relationships/image" Target="../media/image8.png"/><Relationship Id="rId47" Type="http://schemas.openxmlformats.org/officeDocument/2006/relationships/image" Target="../media/image8.png"/><Relationship Id="rId48" Type="http://schemas.openxmlformats.org/officeDocument/2006/relationships/image" Target="../media/image8.png"/><Relationship Id="rId49" Type="http://schemas.openxmlformats.org/officeDocument/2006/relationships/image" Target="../media/image8.png"/><Relationship Id="rId50" Type="http://schemas.openxmlformats.org/officeDocument/2006/relationships/image" Target="../media/image8.png"/><Relationship Id="rId51" Type="http://schemas.openxmlformats.org/officeDocument/2006/relationships/image" Target="../media/image8.png"/><Relationship Id="rId52" Type="http://schemas.openxmlformats.org/officeDocument/2006/relationships/image" Target="../media/image8.png"/><Relationship Id="rId53" Type="http://schemas.openxmlformats.org/officeDocument/2006/relationships/image" Target="../media/image8.png"/><Relationship Id="rId54" Type="http://schemas.openxmlformats.org/officeDocument/2006/relationships/image" Target="../media/image8.png"/><Relationship Id="rId55" Type="http://schemas.openxmlformats.org/officeDocument/2006/relationships/image" Target="../media/image8.png"/><Relationship Id="rId56" Type="http://schemas.openxmlformats.org/officeDocument/2006/relationships/image" Target="../media/image8.png"/><Relationship Id="rId57" Type="http://schemas.openxmlformats.org/officeDocument/2006/relationships/image" Target="../media/image8.png"/><Relationship Id="rId58" Type="http://schemas.openxmlformats.org/officeDocument/2006/relationships/image" Target="../media/image8.png"/><Relationship Id="rId59" Type="http://schemas.openxmlformats.org/officeDocument/2006/relationships/image" Target="../media/image8.png"/><Relationship Id="rId60" Type="http://schemas.openxmlformats.org/officeDocument/2006/relationships/image" Target="../media/image8.png"/><Relationship Id="rId61" Type="http://schemas.openxmlformats.org/officeDocument/2006/relationships/image" Target="../media/image8.png"/><Relationship Id="rId62" Type="http://schemas.openxmlformats.org/officeDocument/2006/relationships/image" Target="../media/image8.png"/><Relationship Id="rId63" Type="http://schemas.openxmlformats.org/officeDocument/2006/relationships/image" Target="../media/image8.png"/><Relationship Id="rId64" Type="http://schemas.openxmlformats.org/officeDocument/2006/relationships/image" Target="../media/image8.png"/><Relationship Id="rId65" Type="http://schemas.openxmlformats.org/officeDocument/2006/relationships/image" Target="../media/image8.png"/><Relationship Id="rId66" Type="http://schemas.openxmlformats.org/officeDocument/2006/relationships/image" Target="../media/image8.png"/><Relationship Id="rId67" Type="http://schemas.openxmlformats.org/officeDocument/2006/relationships/image" Target="../media/image8.png"/><Relationship Id="rId68" Type="http://schemas.openxmlformats.org/officeDocument/2006/relationships/image" Target="../media/image8.png"/><Relationship Id="rId69" Type="http://schemas.openxmlformats.org/officeDocument/2006/relationships/image" Target="../media/image8.png"/><Relationship Id="rId70" Type="http://schemas.openxmlformats.org/officeDocument/2006/relationships/image" Target="../media/image8.png"/><Relationship Id="rId71" Type="http://schemas.openxmlformats.org/officeDocument/2006/relationships/image" Target="../media/image8.png"/><Relationship Id="rId72" Type="http://schemas.openxmlformats.org/officeDocument/2006/relationships/image" Target="../media/image8.png"/><Relationship Id="rId73" Type="http://schemas.openxmlformats.org/officeDocument/2006/relationships/image" Target="../media/image8.png"/><Relationship Id="rId74" Type="http://schemas.openxmlformats.org/officeDocument/2006/relationships/image" Target="../media/image8.png"/><Relationship Id="rId7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35422" r="0" b="0"/>
          <a:stretch/>
        </p:blipFill>
        <p:spPr>
          <a:xfrm>
            <a:off x="1263600" y="2944800"/>
            <a:ext cx="3117960" cy="4795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995480" y="747720"/>
            <a:ext cx="1654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q1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r5:56851374-5685487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2"/>
          <a:srcRect l="0" t="12041" r="0" b="14540"/>
          <a:stretch/>
        </p:blipFill>
        <p:spPr>
          <a:xfrm>
            <a:off x="5572080" y="2944800"/>
            <a:ext cx="3092400" cy="5605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6187680" y="747720"/>
            <a:ext cx="1829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q2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r6:106782358-10679085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3"/>
          <a:srcRect l="0" t="24937" r="0" b="0"/>
          <a:stretch/>
        </p:blipFill>
        <p:spPr>
          <a:xfrm>
            <a:off x="1268280" y="5908680"/>
            <a:ext cx="3122640" cy="73008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1959120" y="3719520"/>
            <a:ext cx="1689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7q2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r7:91935012-91946012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4"/>
          <a:srcRect l="0" t="32909" r="0" b="0"/>
          <a:stretch/>
        </p:blipFill>
        <p:spPr>
          <a:xfrm>
            <a:off x="5560920" y="5910120"/>
            <a:ext cx="3097440" cy="47952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6222960" y="3720960"/>
            <a:ext cx="1724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4q21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r14:44558133-4456313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5"/>
          <a:srcRect l="0" t="13204" r="0" b="18524"/>
          <a:stretch/>
        </p:blipFill>
        <p:spPr>
          <a:xfrm>
            <a:off x="5551560" y="9015480"/>
            <a:ext cx="3114720" cy="40788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6206760" y="6823080"/>
            <a:ext cx="1794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7q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r17: 32763546-3276804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6"/>
          <a:srcRect l="0" t="40978" r="0" b="0"/>
          <a:stretch/>
        </p:blipFill>
        <p:spPr>
          <a:xfrm>
            <a:off x="1268280" y="12082320"/>
            <a:ext cx="3113280" cy="37800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7"/>
          <a:srcRect l="0" t="27087" r="0" b="0"/>
          <a:stretch/>
        </p:blipFill>
        <p:spPr>
          <a:xfrm>
            <a:off x="1265400" y="9024840"/>
            <a:ext cx="3125520" cy="65088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1957320" y="6821640"/>
            <a:ext cx="1724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5q21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r15:53384039-533927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0400" y="39600"/>
            <a:ext cx="203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Laufer et al. additional fil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913040" y="9885240"/>
            <a:ext cx="1808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Xq22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rX:106181709-10618520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771920" y="2871720"/>
            <a:ext cx="110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Monaco"/>
              </a:rPr>
              <a:t>5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141280" y="2871720"/>
            <a:ext cx="146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Monaco"/>
              </a:rPr>
              <a:t>10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525400" y="2871720"/>
            <a:ext cx="146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Monaco"/>
              </a:rPr>
              <a:t>15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919240" y="2871720"/>
            <a:ext cx="146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Monaco"/>
              </a:rPr>
              <a:t>20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304800" y="2871720"/>
            <a:ext cx="146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Monaco"/>
              </a:rPr>
              <a:t>25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696840" y="2871720"/>
            <a:ext cx="146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Monaco"/>
              </a:rPr>
              <a:t>30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082760" y="2871720"/>
            <a:ext cx="146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Monaco"/>
              </a:rPr>
              <a:t>35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"/>
          <p:cNvGrpSpPr/>
          <p:nvPr/>
        </p:nvGrpSpPr>
        <p:grpSpPr>
          <a:xfrm>
            <a:off x="893160" y="1087560"/>
            <a:ext cx="535320" cy="1781280"/>
            <a:chOff x="893160" y="1087560"/>
            <a:chExt cx="535320" cy="1781280"/>
          </a:xfrm>
        </p:grpSpPr>
        <p:sp>
          <p:nvSpPr>
            <p:cNvPr id="64" name=""/>
            <p:cNvSpPr/>
            <p:nvPr/>
          </p:nvSpPr>
          <p:spPr>
            <a:xfrm>
              <a:off x="1185840" y="110484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192320" y="1241280"/>
              <a:ext cx="25200" cy="447840"/>
            </a:xfrm>
            <a:custGeom>
              <a:avLst/>
              <a:gdLst/>
              <a:ahLst/>
              <a:rect l="l" t="t" r="r" b="b"/>
              <a:pathLst>
                <a:path w="34" h="564">
                  <a:moveTo>
                    <a:pt x="34" y="0"/>
                  </a:moveTo>
                  <a:lnTo>
                    <a:pt x="2" y="0"/>
                  </a:lnTo>
                  <a:lnTo>
                    <a:pt x="0" y="564"/>
                  </a:lnTo>
                  <a:lnTo>
                    <a:pt x="32" y="5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165320" y="1681200"/>
              <a:ext cx="25200" cy="111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189080" y="1776240"/>
              <a:ext cx="28440" cy="481320"/>
            </a:xfrm>
            <a:custGeom>
              <a:avLst/>
              <a:gdLst/>
              <a:ahLst/>
              <a:rect l="l" t="t" r="r" b="b"/>
              <a:pathLst>
                <a:path w="35" h="607">
                  <a:moveTo>
                    <a:pt x="32" y="0"/>
                  </a:moveTo>
                  <a:lnTo>
                    <a:pt x="0" y="0"/>
                  </a:lnTo>
                  <a:lnTo>
                    <a:pt x="3" y="607"/>
                  </a:lnTo>
                  <a:lnTo>
                    <a:pt x="35" y="607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166760" y="2271600"/>
              <a:ext cx="27000" cy="427320"/>
            </a:xfrm>
            <a:custGeom>
              <a:avLst/>
              <a:gdLst/>
              <a:ahLst/>
              <a:rect l="l" t="t" r="r" b="b"/>
              <a:pathLst>
                <a:path w="35" h="538">
                  <a:moveTo>
                    <a:pt x="32" y="0"/>
                  </a:moveTo>
                  <a:lnTo>
                    <a:pt x="0" y="0"/>
                  </a:lnTo>
                  <a:lnTo>
                    <a:pt x="3" y="538"/>
                  </a:lnTo>
                  <a:lnTo>
                    <a:pt x="35" y="538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185840" y="271764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rot="16200000">
              <a:off x="1049040" y="13946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g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rot="16200000">
              <a:off x="1035000" y="1671480"/>
              <a:ext cx="14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r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rot="16200000">
              <a:off x="1064520" y="1942560"/>
              <a:ext cx="13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rot="16200000">
              <a:off x="1032480" y="2421720"/>
              <a:ext cx="16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env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893160" y="108756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893160" y="273060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277640" y="193356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244880" y="2792520"/>
              <a:ext cx="18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"/>
          <p:cNvGrpSpPr/>
          <p:nvPr/>
        </p:nvGrpSpPr>
        <p:grpSpPr>
          <a:xfrm>
            <a:off x="1444680" y="1109520"/>
            <a:ext cx="2744640" cy="1762200"/>
            <a:chOff x="1444680" y="1109520"/>
            <a:chExt cx="2744640" cy="1762200"/>
          </a:xfrm>
        </p:grpSpPr>
        <p:sp>
          <p:nvSpPr>
            <p:cNvPr id="79" name=""/>
            <p:cNvSpPr/>
            <p:nvPr/>
          </p:nvSpPr>
          <p:spPr>
            <a:xfrm>
              <a:off x="3022560" y="1488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900520" y="21366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990960" y="2674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892600" y="243540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900520" y="2435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160800" y="249408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1633680" y="2762280"/>
              <a:ext cx="64800" cy="158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1706400" y="2660760"/>
              <a:ext cx="459000" cy="1015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2179800" y="2544840"/>
              <a:ext cx="509400" cy="1094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2689200" y="2493720"/>
              <a:ext cx="231840" cy="50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V="1">
              <a:off x="2928960" y="2442960"/>
              <a:ext cx="210960" cy="428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3139920" y="2428920"/>
              <a:ext cx="73080" cy="144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V="1">
              <a:off x="3278160" y="2071440"/>
              <a:ext cx="115920" cy="219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V="1">
              <a:off x="3213000" y="2100240"/>
              <a:ext cx="65160" cy="79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3402000" y="1991880"/>
              <a:ext cx="341280" cy="79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3743280" y="1969920"/>
              <a:ext cx="115920" cy="223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303640" y="20718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V="1">
              <a:off x="1706400" y="1110960"/>
              <a:ext cx="182880" cy="363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V="1">
              <a:off x="1633680" y="1147680"/>
              <a:ext cx="64800" cy="144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467000" y="1109520"/>
              <a:ext cx="2722320" cy="17398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844640" y="1111320"/>
              <a:ext cx="7920" cy="1754280"/>
            </a:xfrm>
            <a:prstGeom prst="rect">
              <a:avLst/>
            </a:prstGeom>
            <a:blipFill rotWithShape="0">
              <a:blip r:embed="rId8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844640" y="28576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238480" y="1111320"/>
              <a:ext cx="6120" cy="1754280"/>
            </a:xfrm>
            <a:prstGeom prst="rect">
              <a:avLst/>
            </a:prstGeom>
            <a:blipFill rotWithShape="0">
              <a:blip r:embed="rId9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238480" y="28576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622600" y="1111320"/>
              <a:ext cx="7920" cy="1754280"/>
            </a:xfrm>
            <a:prstGeom prst="rect">
              <a:avLst/>
            </a:prstGeom>
            <a:blipFill rotWithShape="0">
              <a:blip r:embed="rId1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622600" y="28576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016080" y="1111320"/>
              <a:ext cx="6480" cy="1754280"/>
            </a:xfrm>
            <a:prstGeom prst="rect">
              <a:avLst/>
            </a:prstGeom>
            <a:blipFill rotWithShape="0">
              <a:blip r:embed="rId1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016080" y="28576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402000" y="1111320"/>
              <a:ext cx="6480" cy="1754280"/>
            </a:xfrm>
            <a:prstGeom prst="rect">
              <a:avLst/>
            </a:prstGeom>
            <a:blipFill rotWithShape="0">
              <a:blip r:embed="rId1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402000" y="28576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794040" y="1111320"/>
              <a:ext cx="7920" cy="1754280"/>
            </a:xfrm>
            <a:prstGeom prst="rect">
              <a:avLst/>
            </a:prstGeom>
            <a:blipFill rotWithShape="0">
              <a:blip r:embed="rId1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794040" y="28576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179960" y="1111320"/>
              <a:ext cx="7920" cy="1754280"/>
            </a:xfrm>
            <a:prstGeom prst="rect">
              <a:avLst/>
            </a:prstGeom>
            <a:blipFill rotWithShape="0">
              <a:blip r:embed="rId14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179960" y="28576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459080" y="1962000"/>
              <a:ext cx="2728800" cy="7920"/>
            </a:xfrm>
            <a:prstGeom prst="rect">
              <a:avLst/>
            </a:prstGeom>
            <a:blipFill rotWithShape="0">
              <a:blip r:embed="rId15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flipH="1">
              <a:off x="1444680" y="1962000"/>
              <a:ext cx="14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459080" y="2820960"/>
              <a:ext cx="2728800" cy="7920"/>
            </a:xfrm>
            <a:prstGeom prst="rect">
              <a:avLst/>
            </a:prstGeom>
            <a:blipFill rotWithShape="0">
              <a:blip r:embed="rId16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flipH="1">
              <a:off x="1444680" y="2820960"/>
              <a:ext cx="14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"/>
          <p:cNvGrpSpPr/>
          <p:nvPr/>
        </p:nvGrpSpPr>
        <p:grpSpPr>
          <a:xfrm>
            <a:off x="5745240" y="1108080"/>
            <a:ext cx="2738520" cy="1836720"/>
            <a:chOff x="5745240" y="1108080"/>
            <a:chExt cx="2738520" cy="1836720"/>
          </a:xfrm>
        </p:grpSpPr>
        <p:sp>
          <p:nvSpPr>
            <p:cNvPr id="118" name=""/>
            <p:cNvSpPr/>
            <p:nvPr/>
          </p:nvSpPr>
          <p:spPr>
            <a:xfrm>
              <a:off x="8317080" y="1152360"/>
              <a:ext cx="612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8221680" y="1108080"/>
              <a:ext cx="87480" cy="442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6058080" y="1245960"/>
              <a:ext cx="196920" cy="109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6043680" y="1245960"/>
              <a:ext cx="6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862600" y="1144440"/>
              <a:ext cx="152640" cy="795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629784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6297840" y="136980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6311880" y="1377720"/>
              <a:ext cx="792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6384960" y="1414440"/>
              <a:ext cx="109440" cy="65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6494400" y="1479600"/>
              <a:ext cx="42840" cy="21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6289920" y="136980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628344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6283440" y="1363680"/>
              <a:ext cx="648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628344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6283440" y="1363680"/>
              <a:ext cx="6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628344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6283440" y="1363680"/>
              <a:ext cx="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6275520" y="1363680"/>
              <a:ext cx="1440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8229600" y="2344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6297840" y="1355760"/>
              <a:ext cx="792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630576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629784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629784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6297840" y="136368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6289920" y="1355760"/>
              <a:ext cx="1584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629784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62899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6289920" y="136368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6289920" y="1363680"/>
              <a:ext cx="792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6289920" y="1363680"/>
              <a:ext cx="1584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62899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62899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6311880" y="137772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6283440" y="1363680"/>
              <a:ext cx="1440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6275520" y="1355760"/>
              <a:ext cx="2232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6275520" y="1355760"/>
              <a:ext cx="792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628344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62899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62899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6537240" y="1501560"/>
              <a:ext cx="79560" cy="43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6616800" y="1544760"/>
              <a:ext cx="81000" cy="442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6319800" y="1384200"/>
              <a:ext cx="57240" cy="302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6703920" y="1589040"/>
              <a:ext cx="115920" cy="65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6311880" y="1377720"/>
              <a:ext cx="7920" cy="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6819840" y="1654200"/>
              <a:ext cx="1440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6988320" y="1741320"/>
              <a:ext cx="65160" cy="36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7053480" y="1778040"/>
              <a:ext cx="188640" cy="1015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6842160" y="1660320"/>
              <a:ext cx="146160" cy="810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6275520" y="1363680"/>
              <a:ext cx="792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7242120" y="1879560"/>
              <a:ext cx="57240" cy="28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7437600" y="1981080"/>
              <a:ext cx="58680" cy="28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629784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6297840" y="1369800"/>
              <a:ext cx="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7299360" y="1908000"/>
              <a:ext cx="138240" cy="73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6297840" y="1369800"/>
              <a:ext cx="792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6297840" y="1369800"/>
              <a:ext cx="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6289920" y="136980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629784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7583400" y="2060640"/>
              <a:ext cx="648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7496280" y="2017800"/>
              <a:ext cx="87120" cy="42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628344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7589880" y="2068560"/>
              <a:ext cx="44640" cy="21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6275520" y="1363680"/>
              <a:ext cx="792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628344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6275520" y="1363680"/>
              <a:ext cx="792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7640640" y="2090520"/>
              <a:ext cx="1440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6275520" y="1363680"/>
              <a:ext cx="792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6289920" y="1369800"/>
              <a:ext cx="792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62755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6275520" y="1363680"/>
              <a:ext cx="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62755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6035760" y="123984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628344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628344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626904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628344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6283440" y="1369800"/>
              <a:ext cx="648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62611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6283440" y="1369800"/>
              <a:ext cx="648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6283440" y="1369800"/>
              <a:ext cx="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628344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6283440" y="1369800"/>
              <a:ext cx="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6255000" y="1355760"/>
              <a:ext cx="612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6007320" y="1224000"/>
              <a:ext cx="2196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62611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628344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62611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6275520" y="1369800"/>
              <a:ext cx="792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62611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628344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62611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6261120" y="1363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627552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627552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627552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627552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627552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626112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626112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626112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6261120" y="1369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626904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6261120" y="137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6261120" y="137772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6261120" y="137772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6261120" y="137772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6261120" y="137772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8402760" y="26715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6007320" y="2840040"/>
              <a:ext cx="2196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5862600" y="2759040"/>
              <a:ext cx="152640" cy="810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6878880" y="2344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7953480" y="2577960"/>
              <a:ext cx="108000" cy="572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7655040" y="2417760"/>
              <a:ext cx="298440" cy="160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8061480" y="2628720"/>
              <a:ext cx="30240" cy="223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8097840" y="2651040"/>
              <a:ext cx="211320" cy="115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8317080" y="2766960"/>
              <a:ext cx="61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 flipV="1">
              <a:off x="7677360" y="2490480"/>
              <a:ext cx="0" cy="61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8461440" y="21272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8461440" y="21272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8461440" y="21272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7786800" y="2432160"/>
              <a:ext cx="648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7793280" y="24321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6596280" y="27954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6596280" y="11890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6289920" y="19587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7677360" y="13842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7677360" y="13842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5764320" y="1111320"/>
              <a:ext cx="2716200" cy="17398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6080040" y="1108080"/>
              <a:ext cx="6480" cy="1754280"/>
            </a:xfrm>
            <a:prstGeom prst="rect">
              <a:avLst/>
            </a:prstGeom>
            <a:blipFill rotWithShape="0">
              <a:blip r:embed="rId17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5983200" y="286848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6080040" y="285444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6399360" y="1108080"/>
              <a:ext cx="7920" cy="1754280"/>
            </a:xfrm>
            <a:prstGeom prst="rect">
              <a:avLst/>
            </a:prstGeom>
            <a:blipFill rotWithShape="0">
              <a:blip r:embed="rId18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6302160" y="286848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2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6399360" y="285444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6718320" y="1108080"/>
              <a:ext cx="7920" cy="1754280"/>
            </a:xfrm>
            <a:prstGeom prst="rect">
              <a:avLst/>
            </a:prstGeom>
            <a:blipFill rotWithShape="0">
              <a:blip r:embed="rId19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6621120" y="286848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3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6718320" y="285444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7039080" y="1108080"/>
              <a:ext cx="6480" cy="1754280"/>
            </a:xfrm>
            <a:prstGeom prst="rect">
              <a:avLst/>
            </a:prstGeom>
            <a:blipFill rotWithShape="0">
              <a:blip r:embed="rId2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6941880" y="286848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4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7039080" y="285444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7358040" y="1108080"/>
              <a:ext cx="6480" cy="1754280"/>
            </a:xfrm>
            <a:prstGeom prst="rect">
              <a:avLst/>
            </a:prstGeom>
            <a:blipFill rotWithShape="0">
              <a:blip r:embed="rId2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7261200" y="286848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7358040" y="285444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7677360" y="1108080"/>
              <a:ext cx="7920" cy="1754280"/>
            </a:xfrm>
            <a:prstGeom prst="rect">
              <a:avLst/>
            </a:prstGeom>
            <a:blipFill rotWithShape="0">
              <a:blip r:embed="rId2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7580160" y="286848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6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7677360" y="285444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7996320" y="1108080"/>
              <a:ext cx="7920" cy="1754280"/>
            </a:xfrm>
            <a:prstGeom prst="rect">
              <a:avLst/>
            </a:prstGeom>
            <a:blipFill rotWithShape="0">
              <a:blip r:embed="rId2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7899120" y="286848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7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7996320" y="285444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8317080" y="1108080"/>
              <a:ext cx="6120" cy="1754280"/>
            </a:xfrm>
            <a:prstGeom prst="rect">
              <a:avLst/>
            </a:prstGeom>
            <a:blipFill rotWithShape="0">
              <a:blip r:embed="rId24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8219880" y="286848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8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8317080" y="285444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5761080" y="1958760"/>
              <a:ext cx="2722680" cy="8280"/>
            </a:xfrm>
            <a:prstGeom prst="rect">
              <a:avLst/>
            </a:prstGeom>
            <a:blipFill rotWithShape="0">
              <a:blip r:embed="rId25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 flipH="1">
              <a:off x="5745240" y="1958760"/>
              <a:ext cx="15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5761080" y="2817720"/>
              <a:ext cx="2722680" cy="7920"/>
            </a:xfrm>
            <a:prstGeom prst="rect">
              <a:avLst/>
            </a:prstGeom>
            <a:blipFill rotWithShape="0">
              <a:blip r:embed="rId26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flipH="1">
              <a:off x="5745240" y="2817720"/>
              <a:ext cx="15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4" name=""/>
          <p:cNvGrpSpPr/>
          <p:nvPr/>
        </p:nvGrpSpPr>
        <p:grpSpPr>
          <a:xfrm>
            <a:off x="5182560" y="1085760"/>
            <a:ext cx="535320" cy="1781280"/>
            <a:chOff x="5182560" y="1085760"/>
            <a:chExt cx="535320" cy="1781280"/>
          </a:xfrm>
        </p:grpSpPr>
        <p:sp>
          <p:nvSpPr>
            <p:cNvPr id="275" name=""/>
            <p:cNvSpPr/>
            <p:nvPr/>
          </p:nvSpPr>
          <p:spPr>
            <a:xfrm>
              <a:off x="5475240" y="110304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5481720" y="1239480"/>
              <a:ext cx="25200" cy="447840"/>
            </a:xfrm>
            <a:custGeom>
              <a:avLst/>
              <a:gdLst/>
              <a:ahLst/>
              <a:rect l="l" t="t" r="r" b="b"/>
              <a:pathLst>
                <a:path w="34" h="564">
                  <a:moveTo>
                    <a:pt x="34" y="0"/>
                  </a:moveTo>
                  <a:lnTo>
                    <a:pt x="2" y="0"/>
                  </a:lnTo>
                  <a:lnTo>
                    <a:pt x="0" y="564"/>
                  </a:lnTo>
                  <a:lnTo>
                    <a:pt x="32" y="5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5454720" y="1679400"/>
              <a:ext cx="25200" cy="111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5478480" y="1774440"/>
              <a:ext cx="28440" cy="481320"/>
            </a:xfrm>
            <a:custGeom>
              <a:avLst/>
              <a:gdLst/>
              <a:ahLst/>
              <a:rect l="l" t="t" r="r" b="b"/>
              <a:pathLst>
                <a:path w="35" h="607">
                  <a:moveTo>
                    <a:pt x="32" y="0"/>
                  </a:moveTo>
                  <a:lnTo>
                    <a:pt x="0" y="0"/>
                  </a:lnTo>
                  <a:lnTo>
                    <a:pt x="3" y="607"/>
                  </a:lnTo>
                  <a:lnTo>
                    <a:pt x="35" y="607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5456160" y="2269800"/>
              <a:ext cx="27000" cy="427320"/>
            </a:xfrm>
            <a:custGeom>
              <a:avLst/>
              <a:gdLst/>
              <a:ahLst/>
              <a:rect l="l" t="t" r="r" b="b"/>
              <a:pathLst>
                <a:path w="35" h="538">
                  <a:moveTo>
                    <a:pt x="32" y="0"/>
                  </a:moveTo>
                  <a:lnTo>
                    <a:pt x="0" y="0"/>
                  </a:lnTo>
                  <a:lnTo>
                    <a:pt x="3" y="538"/>
                  </a:lnTo>
                  <a:lnTo>
                    <a:pt x="35" y="538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5475240" y="271584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 rot="16200000">
              <a:off x="5338440" y="13928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g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 rot="16200000">
              <a:off x="5324400" y="1669680"/>
              <a:ext cx="14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r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 rot="16200000">
              <a:off x="5353920" y="1940760"/>
              <a:ext cx="13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 rot="16200000">
              <a:off x="5321880" y="2419920"/>
              <a:ext cx="16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env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5182560" y="108576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5182560" y="272880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5567040" y="193176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5534280" y="2790720"/>
              <a:ext cx="18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9" name=""/>
          <p:cNvGrpSpPr/>
          <p:nvPr/>
        </p:nvGrpSpPr>
        <p:grpSpPr>
          <a:xfrm>
            <a:off x="1447560" y="4082400"/>
            <a:ext cx="2740320" cy="1835640"/>
            <a:chOff x="1447560" y="4082400"/>
            <a:chExt cx="2740320" cy="1835640"/>
          </a:xfrm>
        </p:grpSpPr>
        <p:sp>
          <p:nvSpPr>
            <p:cNvPr id="290" name=""/>
            <p:cNvSpPr/>
            <p:nvPr/>
          </p:nvSpPr>
          <p:spPr>
            <a:xfrm>
              <a:off x="3925800" y="45036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3925800" y="52448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006640" y="540504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3641760" y="54050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3641760" y="54050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2087640" y="4350960"/>
              <a:ext cx="61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2093760" y="5462280"/>
              <a:ext cx="7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2014560" y="51066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1571760" y="45036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 flipV="1">
              <a:off x="3852720" y="5746320"/>
              <a:ext cx="109800" cy="792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 flipV="1">
              <a:off x="1512720" y="5805360"/>
              <a:ext cx="14400" cy="5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3867120" y="58194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3867120" y="58194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 flipV="1">
              <a:off x="3860640" y="5811120"/>
              <a:ext cx="648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 flipV="1">
              <a:off x="3976560" y="5717520"/>
              <a:ext cx="28800" cy="140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3968640" y="573840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 flipV="1">
              <a:off x="4013280" y="5695200"/>
              <a:ext cx="28440" cy="140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3860640" y="58114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3424320" y="53830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 flipV="1">
              <a:off x="3533760" y="4415760"/>
              <a:ext cx="20520" cy="219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 flipV="1">
              <a:off x="3446640" y="4488840"/>
              <a:ext cx="61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 flipV="1">
              <a:off x="3395520" y="4497120"/>
              <a:ext cx="42840" cy="360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 flipV="1">
              <a:off x="1527120" y="5745960"/>
              <a:ext cx="87480" cy="586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365616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366408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flipV="1">
              <a:off x="3635280" y="4350600"/>
              <a:ext cx="2088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 flipV="1">
              <a:off x="3452760" y="4438440"/>
              <a:ext cx="73080" cy="504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3649680" y="4344840"/>
              <a:ext cx="648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365616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3641760" y="43588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364176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364968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366408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366408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3672000" y="433692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 flipV="1">
              <a:off x="3794040" y="4133160"/>
              <a:ext cx="168480" cy="115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 flipV="1">
              <a:off x="1512720" y="4190400"/>
              <a:ext cx="1440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 flipV="1">
              <a:off x="1527120" y="4133520"/>
              <a:ext cx="87480" cy="568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 flipV="1">
              <a:off x="1658880" y="4082400"/>
              <a:ext cx="34920" cy="219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flipV="1">
              <a:off x="1614600" y="4105080"/>
              <a:ext cx="44280" cy="280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 flipV="1">
              <a:off x="1512720" y="4206240"/>
              <a:ext cx="8280" cy="61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2006640" y="43588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 flipV="1">
              <a:off x="1679400" y="5317920"/>
              <a:ext cx="0" cy="5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3249720" y="451152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 flipV="1">
              <a:off x="3344760" y="4503600"/>
              <a:ext cx="42840" cy="295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 flipV="1">
              <a:off x="3294000" y="4533480"/>
              <a:ext cx="50760" cy="34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 flipV="1">
              <a:off x="3278160" y="4576320"/>
              <a:ext cx="15840" cy="79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 flipV="1">
              <a:off x="3249720" y="4584600"/>
              <a:ext cx="28440" cy="201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 flipV="1">
              <a:off x="2951280" y="4605120"/>
              <a:ext cx="298440" cy="2044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 flipV="1">
              <a:off x="2741760" y="4830120"/>
              <a:ext cx="188640" cy="1234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 flipV="1">
              <a:off x="2930400" y="4815720"/>
              <a:ext cx="2088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 flipV="1">
              <a:off x="2705040" y="4962240"/>
              <a:ext cx="36720" cy="201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 flipV="1">
              <a:off x="2646360" y="4982400"/>
              <a:ext cx="58680" cy="442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 flipV="1">
              <a:off x="2384280" y="5027400"/>
              <a:ext cx="262080" cy="1807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 flipV="1">
              <a:off x="2313000" y="5208480"/>
              <a:ext cx="71280" cy="504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 flipV="1">
              <a:off x="2203560" y="5259240"/>
              <a:ext cx="109440" cy="806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 flipV="1">
              <a:off x="1744560" y="5339880"/>
              <a:ext cx="451080" cy="3106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3641760" y="433692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3641760" y="433692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 flipV="1">
              <a:off x="1658880" y="5651280"/>
              <a:ext cx="85680" cy="583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520" bIns="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3641760" y="433692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 flipV="1">
              <a:off x="1614600" y="5717880"/>
              <a:ext cx="44280" cy="280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364176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364176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 flipV="1">
              <a:off x="3641760" y="4336560"/>
              <a:ext cx="79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364176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 flipV="1">
              <a:off x="3649680" y="4336560"/>
              <a:ext cx="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 flipV="1">
              <a:off x="3641760" y="4336560"/>
              <a:ext cx="1440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 flipV="1">
              <a:off x="3641760" y="4336560"/>
              <a:ext cx="1440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 flipV="1">
              <a:off x="3649680" y="4336560"/>
              <a:ext cx="648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 flipV="1">
              <a:off x="3649680" y="4336560"/>
              <a:ext cx="648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3641760" y="4344840"/>
              <a:ext cx="1440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3656160" y="433692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 flipV="1">
              <a:off x="1512720" y="5819040"/>
              <a:ext cx="8280" cy="61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3656160" y="433692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3656160" y="433692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 flipV="1">
              <a:off x="3649680" y="4344840"/>
              <a:ext cx="0" cy="5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 flipV="1">
              <a:off x="3860640" y="4198320"/>
              <a:ext cx="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 flipV="1">
              <a:off x="3656160" y="4336560"/>
              <a:ext cx="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 flipV="1">
              <a:off x="3656160" y="4336560"/>
              <a:ext cx="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364176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 flipV="1">
              <a:off x="3656160" y="4336560"/>
              <a:ext cx="79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3641760" y="435096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365616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 flipV="1">
              <a:off x="3656160" y="4336560"/>
              <a:ext cx="79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3664080" y="433692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3641760" y="435096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 flipV="1">
              <a:off x="3664080" y="4336560"/>
              <a:ext cx="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664080" y="433692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364968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3641760" y="43588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 flipV="1">
              <a:off x="3649680" y="4344840"/>
              <a:ext cx="6480" cy="5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3635280" y="4358880"/>
              <a:ext cx="648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 flipV="1">
              <a:off x="4013280" y="4082400"/>
              <a:ext cx="28440" cy="219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 flipV="1">
              <a:off x="3759120" y="4249080"/>
              <a:ext cx="34920" cy="219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3641760" y="435096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366408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366408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 flipV="1">
              <a:off x="3700440" y="4277520"/>
              <a:ext cx="58680" cy="363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 flipV="1">
              <a:off x="3656160" y="4314240"/>
              <a:ext cx="44280" cy="298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 flipV="1">
              <a:off x="3968640" y="4125240"/>
              <a:ext cx="79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 flipV="1">
              <a:off x="3976560" y="4105080"/>
              <a:ext cx="28800" cy="201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 flipV="1">
              <a:off x="3613320" y="4358520"/>
              <a:ext cx="28440" cy="205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3641760" y="43588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 flipV="1">
              <a:off x="3584520" y="4379760"/>
              <a:ext cx="28800" cy="216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3576600" y="440172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3641760" y="43588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3641760" y="43588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 flipV="1">
              <a:off x="3562200" y="4401360"/>
              <a:ext cx="14400" cy="140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 flipV="1">
              <a:off x="3656160" y="4344840"/>
              <a:ext cx="0" cy="5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3860640" y="4206600"/>
              <a:ext cx="648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3649680" y="4350960"/>
              <a:ext cx="648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3672000" y="433692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3649680" y="4350960"/>
              <a:ext cx="648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 flipV="1">
              <a:off x="3664080" y="4336560"/>
              <a:ext cx="79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 flipV="1">
              <a:off x="3649680" y="4350600"/>
              <a:ext cx="648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365616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366408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3664080" y="434484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 flipV="1">
              <a:off x="3649680" y="4350600"/>
              <a:ext cx="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364968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3649680" y="4350960"/>
              <a:ext cx="648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365616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366408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365616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365616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365616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365616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3867120" y="42066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3867120" y="42066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3664080" y="434484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3664080" y="434484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3656160" y="435096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366408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3656160" y="435096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 flipV="1">
              <a:off x="3656160" y="4350600"/>
              <a:ext cx="79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366408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 flipV="1">
              <a:off x="3656160" y="4350600"/>
              <a:ext cx="79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3664080" y="43509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 flipV="1">
              <a:off x="3664080" y="4344840"/>
              <a:ext cx="7920" cy="5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3672000" y="43448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 flipV="1">
              <a:off x="3664080" y="4350600"/>
              <a:ext cx="79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 flipV="1">
              <a:off x="3664080" y="4350600"/>
              <a:ext cx="7920" cy="75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3664080" y="435096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3664080" y="435096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3664080" y="435096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1465200" y="4086000"/>
              <a:ext cx="2719440" cy="17362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2697120" y="4082760"/>
              <a:ext cx="7920" cy="1750680"/>
            </a:xfrm>
            <a:prstGeom prst="rect">
              <a:avLst/>
            </a:prstGeom>
            <a:blipFill rotWithShape="0">
              <a:blip r:embed="rId27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2599920" y="58417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2697120" y="58258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3932280" y="4082760"/>
              <a:ext cx="7920" cy="1750680"/>
            </a:xfrm>
            <a:prstGeom prst="rect">
              <a:avLst/>
            </a:prstGeom>
            <a:blipFill rotWithShape="0">
              <a:blip r:embed="rId28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3812040" y="5841720"/>
              <a:ext cx="18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>
              <a:off x="3932280" y="58258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1461960" y="4932000"/>
              <a:ext cx="2725920" cy="7560"/>
            </a:xfrm>
            <a:prstGeom prst="rect">
              <a:avLst/>
            </a:prstGeom>
            <a:blipFill rotWithShape="0">
              <a:blip r:embed="rId29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 flipH="1">
              <a:off x="1447560" y="4932000"/>
              <a:ext cx="140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1461960" y="5789160"/>
              <a:ext cx="2725920" cy="7920"/>
            </a:xfrm>
            <a:prstGeom prst="rect">
              <a:avLst/>
            </a:prstGeom>
            <a:blipFill rotWithShape="0">
              <a:blip r:embed="rId3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 flipH="1">
              <a:off x="1447560" y="5789160"/>
              <a:ext cx="140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7" name=""/>
          <p:cNvGrpSpPr/>
          <p:nvPr/>
        </p:nvGrpSpPr>
        <p:grpSpPr>
          <a:xfrm>
            <a:off x="882000" y="4062240"/>
            <a:ext cx="535320" cy="1781280"/>
            <a:chOff x="882000" y="4062240"/>
            <a:chExt cx="535320" cy="1781280"/>
          </a:xfrm>
        </p:grpSpPr>
        <p:sp>
          <p:nvSpPr>
            <p:cNvPr id="448" name=""/>
            <p:cNvSpPr/>
            <p:nvPr/>
          </p:nvSpPr>
          <p:spPr>
            <a:xfrm>
              <a:off x="1174680" y="407952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1181160" y="4215960"/>
              <a:ext cx="25200" cy="447840"/>
            </a:xfrm>
            <a:custGeom>
              <a:avLst/>
              <a:gdLst/>
              <a:ahLst/>
              <a:rect l="l" t="t" r="r" b="b"/>
              <a:pathLst>
                <a:path w="34" h="564">
                  <a:moveTo>
                    <a:pt x="34" y="0"/>
                  </a:moveTo>
                  <a:lnTo>
                    <a:pt x="2" y="0"/>
                  </a:lnTo>
                  <a:lnTo>
                    <a:pt x="0" y="564"/>
                  </a:lnTo>
                  <a:lnTo>
                    <a:pt x="32" y="5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1154160" y="4655880"/>
              <a:ext cx="25200" cy="111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1177920" y="4750920"/>
              <a:ext cx="28440" cy="481320"/>
            </a:xfrm>
            <a:custGeom>
              <a:avLst/>
              <a:gdLst/>
              <a:ahLst/>
              <a:rect l="l" t="t" r="r" b="b"/>
              <a:pathLst>
                <a:path w="35" h="607">
                  <a:moveTo>
                    <a:pt x="32" y="0"/>
                  </a:moveTo>
                  <a:lnTo>
                    <a:pt x="0" y="0"/>
                  </a:lnTo>
                  <a:lnTo>
                    <a:pt x="3" y="607"/>
                  </a:lnTo>
                  <a:lnTo>
                    <a:pt x="35" y="607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1155600" y="5246280"/>
              <a:ext cx="27000" cy="427320"/>
            </a:xfrm>
            <a:custGeom>
              <a:avLst/>
              <a:gdLst/>
              <a:ahLst/>
              <a:rect l="l" t="t" r="r" b="b"/>
              <a:pathLst>
                <a:path w="35" h="538">
                  <a:moveTo>
                    <a:pt x="32" y="0"/>
                  </a:moveTo>
                  <a:lnTo>
                    <a:pt x="0" y="0"/>
                  </a:lnTo>
                  <a:lnTo>
                    <a:pt x="3" y="538"/>
                  </a:lnTo>
                  <a:lnTo>
                    <a:pt x="35" y="538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1174680" y="569232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 rot="16200000">
              <a:off x="1037880" y="43693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g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 rot="16200000">
              <a:off x="1023840" y="4646160"/>
              <a:ext cx="14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r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 rot="16200000">
              <a:off x="1053360" y="4917240"/>
              <a:ext cx="13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 rot="16200000">
              <a:off x="1021320" y="5396400"/>
              <a:ext cx="16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env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882000" y="406224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882000" y="570528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1266480" y="49082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1233720" y="5767200"/>
              <a:ext cx="18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2" name=""/>
          <p:cNvGrpSpPr/>
          <p:nvPr/>
        </p:nvGrpSpPr>
        <p:grpSpPr>
          <a:xfrm>
            <a:off x="5745240" y="4082760"/>
            <a:ext cx="2783520" cy="1837080"/>
            <a:chOff x="5745240" y="4082760"/>
            <a:chExt cx="2783520" cy="1837080"/>
          </a:xfrm>
        </p:grpSpPr>
        <p:sp>
          <p:nvSpPr>
            <p:cNvPr id="463" name=""/>
            <p:cNvSpPr/>
            <p:nvPr/>
          </p:nvSpPr>
          <p:spPr>
            <a:xfrm>
              <a:off x="8348760" y="4505400"/>
              <a:ext cx="6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6996240" y="4352760"/>
              <a:ext cx="6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6827760" y="5457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6827760" y="5457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6996240" y="5465880"/>
              <a:ext cx="6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 flipV="1">
              <a:off x="5978520" y="5435280"/>
              <a:ext cx="930240" cy="2919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 flipV="1">
              <a:off x="5919840" y="5734080"/>
              <a:ext cx="58680" cy="158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 flipV="1">
              <a:off x="6908760" y="5226120"/>
              <a:ext cx="676440" cy="2095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 flipV="1">
              <a:off x="7585200" y="5203800"/>
              <a:ext cx="57240" cy="223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 flipV="1">
              <a:off x="8050320" y="5065560"/>
              <a:ext cx="50760" cy="144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 flipV="1">
              <a:off x="8101080" y="5035320"/>
              <a:ext cx="109440" cy="298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7831080" y="514512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 flipV="1">
              <a:off x="7839000" y="5094000"/>
              <a:ext cx="160560" cy="50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 flipV="1">
              <a:off x="7650360" y="5144760"/>
              <a:ext cx="180720" cy="586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 flipV="1">
              <a:off x="7999560" y="5087880"/>
              <a:ext cx="28440" cy="64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 flipV="1">
              <a:off x="5919840" y="4119480"/>
              <a:ext cx="58680" cy="144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 flipV="1">
              <a:off x="5978520" y="4082760"/>
              <a:ext cx="122400" cy="363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5762880" y="4086360"/>
              <a:ext cx="2720880" cy="17398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6029280" y="4083120"/>
              <a:ext cx="6480" cy="1754280"/>
            </a:xfrm>
            <a:prstGeom prst="rect">
              <a:avLst/>
            </a:prstGeom>
            <a:blipFill rotWithShape="0">
              <a:blip r:embed="rId3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5955120" y="584352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602928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6297840" y="4083120"/>
              <a:ext cx="7920" cy="1754280"/>
            </a:xfrm>
            <a:prstGeom prst="rect">
              <a:avLst/>
            </a:prstGeom>
            <a:blipFill rotWithShape="0">
              <a:blip r:embed="rId3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6200640" y="58435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629784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6573960" y="4083120"/>
              <a:ext cx="7920" cy="1754280"/>
            </a:xfrm>
            <a:prstGeom prst="rect">
              <a:avLst/>
            </a:prstGeom>
            <a:blipFill rotWithShape="0">
              <a:blip r:embed="rId3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6476760" y="58435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657396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6843960" y="4083120"/>
              <a:ext cx="6120" cy="1754280"/>
            </a:xfrm>
            <a:prstGeom prst="rect">
              <a:avLst/>
            </a:prstGeom>
            <a:blipFill rotWithShape="0">
              <a:blip r:embed="rId34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6746760" y="58435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2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684396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7120080" y="4083120"/>
              <a:ext cx="6120" cy="1754280"/>
            </a:xfrm>
            <a:prstGeom prst="rect">
              <a:avLst/>
            </a:prstGeom>
            <a:blipFill rotWithShape="0">
              <a:blip r:embed="rId35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7022880" y="58435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2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712008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7388280" y="4083120"/>
              <a:ext cx="7920" cy="1754280"/>
            </a:xfrm>
            <a:prstGeom prst="rect">
              <a:avLst/>
            </a:prstGeom>
            <a:blipFill rotWithShape="0">
              <a:blip r:embed="rId36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7291080" y="58435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3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738828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7664400" y="4083120"/>
              <a:ext cx="7920" cy="1754280"/>
            </a:xfrm>
            <a:prstGeom prst="rect">
              <a:avLst/>
            </a:prstGeom>
            <a:blipFill rotWithShape="0">
              <a:blip r:embed="rId37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7567560" y="58435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3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766440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7934400" y="4083120"/>
              <a:ext cx="6480" cy="1754280"/>
            </a:xfrm>
            <a:prstGeom prst="rect">
              <a:avLst/>
            </a:prstGeom>
            <a:blipFill rotWithShape="0">
              <a:blip r:embed="rId38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7837200" y="58435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4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793440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8210520" y="4083120"/>
              <a:ext cx="6480" cy="1754280"/>
            </a:xfrm>
            <a:prstGeom prst="rect">
              <a:avLst/>
            </a:prstGeom>
            <a:blipFill rotWithShape="0">
              <a:blip r:embed="rId39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8113680" y="58435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4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821052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8479080" y="4083120"/>
              <a:ext cx="7920" cy="1754280"/>
            </a:xfrm>
            <a:prstGeom prst="rect">
              <a:avLst/>
            </a:prstGeom>
            <a:blipFill rotWithShape="0">
              <a:blip r:embed="rId4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8381880" y="58435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8479080" y="5829480"/>
              <a:ext cx="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5759640" y="4933800"/>
              <a:ext cx="2727360" cy="7920"/>
            </a:xfrm>
            <a:prstGeom prst="rect">
              <a:avLst/>
            </a:prstGeom>
            <a:blipFill rotWithShape="0">
              <a:blip r:embed="rId4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 flipH="1">
              <a:off x="5745240" y="4933800"/>
              <a:ext cx="14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5759640" y="5792760"/>
              <a:ext cx="2727360" cy="7920"/>
            </a:xfrm>
            <a:prstGeom prst="rect">
              <a:avLst/>
            </a:prstGeom>
            <a:blipFill rotWithShape="0">
              <a:blip r:embed="rId4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 flipH="1">
              <a:off x="5745240" y="5792760"/>
              <a:ext cx="14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5" name=""/>
          <p:cNvGrpSpPr/>
          <p:nvPr/>
        </p:nvGrpSpPr>
        <p:grpSpPr>
          <a:xfrm>
            <a:off x="5185800" y="4067280"/>
            <a:ext cx="535320" cy="1781280"/>
            <a:chOff x="5185800" y="4067280"/>
            <a:chExt cx="535320" cy="1781280"/>
          </a:xfrm>
        </p:grpSpPr>
        <p:sp>
          <p:nvSpPr>
            <p:cNvPr id="516" name=""/>
            <p:cNvSpPr/>
            <p:nvPr/>
          </p:nvSpPr>
          <p:spPr>
            <a:xfrm>
              <a:off x="5478480" y="408456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5484960" y="4221000"/>
              <a:ext cx="25200" cy="447840"/>
            </a:xfrm>
            <a:custGeom>
              <a:avLst/>
              <a:gdLst/>
              <a:ahLst/>
              <a:rect l="l" t="t" r="r" b="b"/>
              <a:pathLst>
                <a:path w="34" h="564">
                  <a:moveTo>
                    <a:pt x="34" y="0"/>
                  </a:moveTo>
                  <a:lnTo>
                    <a:pt x="2" y="0"/>
                  </a:lnTo>
                  <a:lnTo>
                    <a:pt x="0" y="564"/>
                  </a:lnTo>
                  <a:lnTo>
                    <a:pt x="32" y="5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5457960" y="4660920"/>
              <a:ext cx="25200" cy="111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5481720" y="4755960"/>
              <a:ext cx="28440" cy="481320"/>
            </a:xfrm>
            <a:custGeom>
              <a:avLst/>
              <a:gdLst/>
              <a:ahLst/>
              <a:rect l="l" t="t" r="r" b="b"/>
              <a:pathLst>
                <a:path w="35" h="607">
                  <a:moveTo>
                    <a:pt x="32" y="0"/>
                  </a:moveTo>
                  <a:lnTo>
                    <a:pt x="0" y="0"/>
                  </a:lnTo>
                  <a:lnTo>
                    <a:pt x="3" y="607"/>
                  </a:lnTo>
                  <a:lnTo>
                    <a:pt x="35" y="607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5459400" y="5251320"/>
              <a:ext cx="27000" cy="427320"/>
            </a:xfrm>
            <a:custGeom>
              <a:avLst/>
              <a:gdLst/>
              <a:ahLst/>
              <a:rect l="l" t="t" r="r" b="b"/>
              <a:pathLst>
                <a:path w="35" h="538">
                  <a:moveTo>
                    <a:pt x="32" y="0"/>
                  </a:moveTo>
                  <a:lnTo>
                    <a:pt x="0" y="0"/>
                  </a:lnTo>
                  <a:lnTo>
                    <a:pt x="3" y="538"/>
                  </a:lnTo>
                  <a:lnTo>
                    <a:pt x="35" y="538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5478480" y="569736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 rot="16200000">
              <a:off x="5341680" y="43743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g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 rot="16200000">
              <a:off x="5327640" y="4651200"/>
              <a:ext cx="14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r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 rot="16200000">
              <a:off x="5357160" y="4922280"/>
              <a:ext cx="13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 rot="16200000">
              <a:off x="5325120" y="5401440"/>
              <a:ext cx="16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env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5185800" y="406728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5185800" y="571032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5570280" y="491328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5537520" y="5772240"/>
              <a:ext cx="18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0" name=""/>
          <p:cNvGrpSpPr/>
          <p:nvPr/>
        </p:nvGrpSpPr>
        <p:grpSpPr>
          <a:xfrm>
            <a:off x="811080" y="7189200"/>
            <a:ext cx="3379680" cy="1960920"/>
            <a:chOff x="811080" y="7189200"/>
            <a:chExt cx="3379680" cy="1960920"/>
          </a:xfrm>
        </p:grpSpPr>
        <p:pic>
          <p:nvPicPr>
            <p:cNvPr id="531" name="" descr=""/>
            <p:cNvPicPr/>
            <p:nvPr/>
          </p:nvPicPr>
          <p:blipFill>
            <a:blip r:embed="rId43"/>
            <a:stretch/>
          </p:blipFill>
          <p:spPr>
            <a:xfrm>
              <a:off x="841320" y="8270640"/>
              <a:ext cx="87120" cy="879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2" name="" descr=""/>
            <p:cNvPicPr/>
            <p:nvPr/>
          </p:nvPicPr>
          <p:blipFill>
            <a:blip r:embed="rId44"/>
            <a:stretch/>
          </p:blipFill>
          <p:spPr>
            <a:xfrm>
              <a:off x="811080" y="7626240"/>
              <a:ext cx="87120" cy="880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3" name=""/>
            <p:cNvSpPr/>
            <p:nvPr/>
          </p:nvSpPr>
          <p:spPr>
            <a:xfrm>
              <a:off x="3841560" y="76118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2068200" y="8513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2074680" y="8513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3965400" y="87897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3965400" y="87897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2178000" y="8572320"/>
              <a:ext cx="61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2714400" y="85723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2074680" y="82152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2074680" y="82152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3762000" y="89280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 flipV="1">
              <a:off x="3768480" y="8921520"/>
              <a:ext cx="0" cy="64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 flipV="1">
              <a:off x="3768480" y="8848080"/>
              <a:ext cx="138240" cy="730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 flipV="1">
              <a:off x="1566720" y="8797320"/>
              <a:ext cx="95040" cy="586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1661760" y="8797680"/>
              <a:ext cx="648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 flipV="1">
              <a:off x="1668240" y="8738640"/>
              <a:ext cx="109440" cy="586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 flipV="1">
              <a:off x="1784160" y="8724600"/>
              <a:ext cx="14400" cy="144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 flipV="1">
              <a:off x="1806480" y="8645400"/>
              <a:ext cx="137880" cy="792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 flipV="1">
              <a:off x="1952280" y="8623080"/>
              <a:ext cx="36720" cy="223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 flipV="1">
              <a:off x="1989000" y="8412120"/>
              <a:ext cx="377640" cy="2030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 flipV="1">
              <a:off x="2728800" y="7975440"/>
              <a:ext cx="444240" cy="239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 flipV="1">
              <a:off x="2366640" y="8214840"/>
              <a:ext cx="355680" cy="1969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 flipV="1">
              <a:off x="3463560" y="7735320"/>
              <a:ext cx="130320" cy="730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 flipV="1">
              <a:off x="3173040" y="7814880"/>
              <a:ext cx="282600" cy="1522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3593880" y="773568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 flipV="1">
              <a:off x="3608280" y="7654320"/>
              <a:ext cx="131760" cy="730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4089240" y="74660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4089240" y="74660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4089240" y="74660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4089240" y="74595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4089240" y="74516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4089240" y="74516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 flipV="1">
              <a:off x="4089240" y="7445160"/>
              <a:ext cx="0" cy="64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 flipV="1">
              <a:off x="1566720" y="7189200"/>
              <a:ext cx="101520" cy="507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 flipV="1">
              <a:off x="3768480" y="7234200"/>
              <a:ext cx="138240" cy="712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3768480" y="73134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 flipV="1">
              <a:off x="3762000" y="7313400"/>
              <a:ext cx="0" cy="79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 flipV="1">
              <a:off x="3746160" y="7321320"/>
              <a:ext cx="7920" cy="64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1468080" y="7192800"/>
              <a:ext cx="2719440" cy="17398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1777680" y="7189560"/>
              <a:ext cx="6480" cy="1754280"/>
            </a:xfrm>
            <a:prstGeom prst="rect">
              <a:avLst/>
            </a:prstGeom>
            <a:blipFill rotWithShape="0">
              <a:blip r:embed="rId45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1680840" y="89503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1777680" y="893592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2090520" y="7189560"/>
              <a:ext cx="6480" cy="1754280"/>
            </a:xfrm>
            <a:prstGeom prst="rect">
              <a:avLst/>
            </a:prstGeom>
            <a:blipFill rotWithShape="0">
              <a:blip r:embed="rId46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1993320" y="89503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2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2090520" y="893592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2401560" y="7189560"/>
              <a:ext cx="7920" cy="1754280"/>
            </a:xfrm>
            <a:prstGeom prst="rect">
              <a:avLst/>
            </a:prstGeom>
            <a:blipFill rotWithShape="0">
              <a:blip r:embed="rId47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2306160" y="89503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3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2401560" y="893592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2714400" y="7189560"/>
              <a:ext cx="7920" cy="1754280"/>
            </a:xfrm>
            <a:prstGeom prst="rect">
              <a:avLst/>
            </a:prstGeom>
            <a:blipFill rotWithShape="0">
              <a:blip r:embed="rId48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2617200" y="89503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4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2714400" y="893592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3027240" y="7189560"/>
              <a:ext cx="7920" cy="1754280"/>
            </a:xfrm>
            <a:prstGeom prst="rect">
              <a:avLst/>
            </a:prstGeom>
            <a:blipFill rotWithShape="0">
              <a:blip r:embed="rId49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2930040" y="89503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3027240" y="893592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3339720" y="7189560"/>
              <a:ext cx="8280" cy="1754280"/>
            </a:xfrm>
            <a:prstGeom prst="rect">
              <a:avLst/>
            </a:prstGeom>
            <a:blipFill rotWithShape="0">
              <a:blip r:embed="rId5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3242880" y="89503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6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3339720" y="893592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3652560" y="7189560"/>
              <a:ext cx="6480" cy="1754280"/>
            </a:xfrm>
            <a:prstGeom prst="rect">
              <a:avLst/>
            </a:prstGeom>
            <a:blipFill rotWithShape="0">
              <a:blip r:embed="rId5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3555360" y="89503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7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3652560" y="893592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3965400" y="7189560"/>
              <a:ext cx="6480" cy="1754280"/>
            </a:xfrm>
            <a:prstGeom prst="rect">
              <a:avLst/>
            </a:prstGeom>
            <a:blipFill rotWithShape="0">
              <a:blip r:embed="rId5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3868200" y="895032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8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3965400" y="893592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1465200" y="8040600"/>
              <a:ext cx="2725560" cy="7920"/>
            </a:xfrm>
            <a:prstGeom prst="rect">
              <a:avLst/>
            </a:prstGeom>
            <a:blipFill rotWithShape="0">
              <a:blip r:embed="rId5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 flipH="1">
              <a:off x="1450800" y="8040600"/>
              <a:ext cx="14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1465200" y="8899560"/>
              <a:ext cx="2725560" cy="7920"/>
            </a:xfrm>
            <a:prstGeom prst="rect">
              <a:avLst/>
            </a:prstGeom>
            <a:blipFill rotWithShape="0">
              <a:blip r:embed="rId54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 flipH="1">
              <a:off x="1450800" y="8899560"/>
              <a:ext cx="14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9" name=""/>
          <p:cNvGrpSpPr/>
          <p:nvPr/>
        </p:nvGrpSpPr>
        <p:grpSpPr>
          <a:xfrm>
            <a:off x="899640" y="7167600"/>
            <a:ext cx="535320" cy="1781280"/>
            <a:chOff x="899640" y="7167600"/>
            <a:chExt cx="535320" cy="1781280"/>
          </a:xfrm>
        </p:grpSpPr>
        <p:sp>
          <p:nvSpPr>
            <p:cNvPr id="600" name=""/>
            <p:cNvSpPr/>
            <p:nvPr/>
          </p:nvSpPr>
          <p:spPr>
            <a:xfrm>
              <a:off x="1192320" y="718488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1198800" y="7321320"/>
              <a:ext cx="25200" cy="447840"/>
            </a:xfrm>
            <a:custGeom>
              <a:avLst/>
              <a:gdLst/>
              <a:ahLst/>
              <a:rect l="l" t="t" r="r" b="b"/>
              <a:pathLst>
                <a:path w="34" h="564">
                  <a:moveTo>
                    <a:pt x="34" y="0"/>
                  </a:moveTo>
                  <a:lnTo>
                    <a:pt x="2" y="0"/>
                  </a:lnTo>
                  <a:lnTo>
                    <a:pt x="0" y="564"/>
                  </a:lnTo>
                  <a:lnTo>
                    <a:pt x="32" y="5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1171800" y="7761240"/>
              <a:ext cx="25200" cy="111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1195560" y="7856280"/>
              <a:ext cx="28440" cy="481320"/>
            </a:xfrm>
            <a:custGeom>
              <a:avLst/>
              <a:gdLst/>
              <a:ahLst/>
              <a:rect l="l" t="t" r="r" b="b"/>
              <a:pathLst>
                <a:path w="35" h="607">
                  <a:moveTo>
                    <a:pt x="32" y="0"/>
                  </a:moveTo>
                  <a:lnTo>
                    <a:pt x="0" y="0"/>
                  </a:lnTo>
                  <a:lnTo>
                    <a:pt x="3" y="607"/>
                  </a:lnTo>
                  <a:lnTo>
                    <a:pt x="35" y="607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1173240" y="8351640"/>
              <a:ext cx="27000" cy="427320"/>
            </a:xfrm>
            <a:custGeom>
              <a:avLst/>
              <a:gdLst/>
              <a:ahLst/>
              <a:rect l="l" t="t" r="r" b="b"/>
              <a:pathLst>
                <a:path w="35" h="538">
                  <a:moveTo>
                    <a:pt x="32" y="0"/>
                  </a:moveTo>
                  <a:lnTo>
                    <a:pt x="0" y="0"/>
                  </a:lnTo>
                  <a:lnTo>
                    <a:pt x="3" y="538"/>
                  </a:lnTo>
                  <a:lnTo>
                    <a:pt x="35" y="538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1192320" y="879768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"/>
            <p:cNvSpPr/>
            <p:nvPr/>
          </p:nvSpPr>
          <p:spPr>
            <a:xfrm rot="16200000">
              <a:off x="1055520" y="74746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g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"/>
            <p:cNvSpPr/>
            <p:nvPr/>
          </p:nvSpPr>
          <p:spPr>
            <a:xfrm rot="16200000">
              <a:off x="1041480" y="7751520"/>
              <a:ext cx="14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r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"/>
            <p:cNvSpPr/>
            <p:nvPr/>
          </p:nvSpPr>
          <p:spPr>
            <a:xfrm rot="16200000">
              <a:off x="1071000" y="8022600"/>
              <a:ext cx="13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"/>
            <p:cNvSpPr/>
            <p:nvPr/>
          </p:nvSpPr>
          <p:spPr>
            <a:xfrm rot="16200000">
              <a:off x="1038960" y="8501760"/>
              <a:ext cx="16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env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"/>
            <p:cNvSpPr/>
            <p:nvPr/>
          </p:nvSpPr>
          <p:spPr>
            <a:xfrm>
              <a:off x="899640" y="716760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"/>
            <p:cNvSpPr/>
            <p:nvPr/>
          </p:nvSpPr>
          <p:spPr>
            <a:xfrm>
              <a:off x="899640" y="881064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"/>
            <p:cNvSpPr/>
            <p:nvPr/>
          </p:nvSpPr>
          <p:spPr>
            <a:xfrm>
              <a:off x="1284120" y="801360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"/>
            <p:cNvSpPr/>
            <p:nvPr/>
          </p:nvSpPr>
          <p:spPr>
            <a:xfrm>
              <a:off x="1251360" y="8872560"/>
              <a:ext cx="18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4" name=""/>
          <p:cNvGrpSpPr/>
          <p:nvPr/>
        </p:nvGrpSpPr>
        <p:grpSpPr>
          <a:xfrm>
            <a:off x="5745240" y="7188120"/>
            <a:ext cx="2780280" cy="1833840"/>
            <a:chOff x="5745240" y="7188120"/>
            <a:chExt cx="2780280" cy="1833840"/>
          </a:xfrm>
        </p:grpSpPr>
        <p:sp>
          <p:nvSpPr>
            <p:cNvPr id="615" name=""/>
            <p:cNvSpPr/>
            <p:nvPr/>
          </p:nvSpPr>
          <p:spPr>
            <a:xfrm>
              <a:off x="8097840" y="7188120"/>
              <a:ext cx="182520" cy="50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"/>
            <p:cNvSpPr/>
            <p:nvPr/>
          </p:nvSpPr>
          <p:spPr>
            <a:xfrm>
              <a:off x="6029280" y="8211960"/>
              <a:ext cx="174600" cy="51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"/>
            <p:cNvSpPr/>
            <p:nvPr/>
          </p:nvSpPr>
          <p:spPr>
            <a:xfrm>
              <a:off x="7110360" y="8508960"/>
              <a:ext cx="792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7118280" y="8516880"/>
              <a:ext cx="138240" cy="36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"/>
            <p:cNvSpPr/>
            <p:nvPr/>
          </p:nvSpPr>
          <p:spPr>
            <a:xfrm>
              <a:off x="6269040" y="8277120"/>
              <a:ext cx="355680" cy="1018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"/>
            <p:cNvSpPr/>
            <p:nvPr/>
          </p:nvSpPr>
          <p:spPr>
            <a:xfrm>
              <a:off x="7262640" y="8559720"/>
              <a:ext cx="203400" cy="58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"/>
            <p:cNvSpPr/>
            <p:nvPr/>
          </p:nvSpPr>
          <p:spPr>
            <a:xfrm>
              <a:off x="7473960" y="8618400"/>
              <a:ext cx="806400" cy="225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"/>
            <p:cNvSpPr/>
            <p:nvPr/>
          </p:nvSpPr>
          <p:spPr>
            <a:xfrm>
              <a:off x="6210360" y="8263080"/>
              <a:ext cx="6516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"/>
            <p:cNvSpPr/>
            <p:nvPr/>
          </p:nvSpPr>
          <p:spPr>
            <a:xfrm>
              <a:off x="6624720" y="8379000"/>
              <a:ext cx="442800" cy="123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"/>
            <p:cNvSpPr/>
            <p:nvPr/>
          </p:nvSpPr>
          <p:spPr>
            <a:xfrm>
              <a:off x="7067520" y="8502480"/>
              <a:ext cx="4284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"/>
            <p:cNvSpPr/>
            <p:nvPr/>
          </p:nvSpPr>
          <p:spPr>
            <a:xfrm>
              <a:off x="6523200" y="887256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"/>
            <p:cNvSpPr/>
            <p:nvPr/>
          </p:nvSpPr>
          <p:spPr>
            <a:xfrm>
              <a:off x="7270920" y="85676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"/>
            <p:cNvSpPr/>
            <p:nvPr/>
          </p:nvSpPr>
          <p:spPr>
            <a:xfrm>
              <a:off x="7270920" y="856764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"/>
            <p:cNvSpPr/>
            <p:nvPr/>
          </p:nvSpPr>
          <p:spPr>
            <a:xfrm flipV="1">
              <a:off x="7074000" y="8567640"/>
              <a:ext cx="7920" cy="64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"/>
            <p:cNvSpPr/>
            <p:nvPr/>
          </p:nvSpPr>
          <p:spPr>
            <a:xfrm>
              <a:off x="6035760" y="856764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"/>
            <p:cNvSpPr/>
            <p:nvPr/>
          </p:nvSpPr>
          <p:spPr>
            <a:xfrm>
              <a:off x="8388360" y="752940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"/>
            <p:cNvSpPr/>
            <p:nvPr/>
          </p:nvSpPr>
          <p:spPr>
            <a:xfrm>
              <a:off x="6523200" y="7267680"/>
              <a:ext cx="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"/>
            <p:cNvSpPr/>
            <p:nvPr/>
          </p:nvSpPr>
          <p:spPr>
            <a:xfrm>
              <a:off x="7074000" y="746460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"/>
            <p:cNvSpPr/>
            <p:nvPr/>
          </p:nvSpPr>
          <p:spPr>
            <a:xfrm>
              <a:off x="7081920" y="746460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"/>
            <p:cNvSpPr/>
            <p:nvPr/>
          </p:nvSpPr>
          <p:spPr>
            <a:xfrm>
              <a:off x="5764320" y="7191360"/>
              <a:ext cx="2716200" cy="173520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"/>
            <p:cNvSpPr/>
            <p:nvPr/>
          </p:nvSpPr>
          <p:spPr>
            <a:xfrm>
              <a:off x="6058080" y="7188120"/>
              <a:ext cx="7920" cy="1749600"/>
            </a:xfrm>
            <a:prstGeom prst="rect">
              <a:avLst/>
            </a:prstGeom>
            <a:blipFill rotWithShape="0">
              <a:blip r:embed="rId55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"/>
            <p:cNvSpPr/>
            <p:nvPr/>
          </p:nvSpPr>
          <p:spPr>
            <a:xfrm>
              <a:off x="5985360" y="894564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"/>
            <p:cNvSpPr/>
            <p:nvPr/>
          </p:nvSpPr>
          <p:spPr>
            <a:xfrm>
              <a:off x="6058080" y="8929800"/>
              <a:ext cx="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"/>
            <p:cNvSpPr/>
            <p:nvPr/>
          </p:nvSpPr>
          <p:spPr>
            <a:xfrm>
              <a:off x="6362640" y="7188120"/>
              <a:ext cx="7920" cy="1749600"/>
            </a:xfrm>
            <a:prstGeom prst="rect">
              <a:avLst/>
            </a:prstGeom>
            <a:blipFill rotWithShape="0">
              <a:blip r:embed="rId56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"/>
            <p:cNvSpPr/>
            <p:nvPr/>
          </p:nvSpPr>
          <p:spPr>
            <a:xfrm>
              <a:off x="6265440" y="89456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"/>
            <p:cNvSpPr/>
            <p:nvPr/>
          </p:nvSpPr>
          <p:spPr>
            <a:xfrm>
              <a:off x="6362640" y="8929800"/>
              <a:ext cx="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"/>
            <p:cNvSpPr/>
            <p:nvPr/>
          </p:nvSpPr>
          <p:spPr>
            <a:xfrm>
              <a:off x="6661080" y="7188120"/>
              <a:ext cx="6480" cy="1749600"/>
            </a:xfrm>
            <a:prstGeom prst="rect">
              <a:avLst/>
            </a:prstGeom>
            <a:blipFill rotWithShape="0">
              <a:blip r:embed="rId57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"/>
            <p:cNvSpPr/>
            <p:nvPr/>
          </p:nvSpPr>
          <p:spPr>
            <a:xfrm>
              <a:off x="6563880" y="89456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"/>
            <p:cNvSpPr/>
            <p:nvPr/>
          </p:nvSpPr>
          <p:spPr>
            <a:xfrm>
              <a:off x="6661080" y="8929800"/>
              <a:ext cx="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"/>
            <p:cNvSpPr/>
            <p:nvPr/>
          </p:nvSpPr>
          <p:spPr>
            <a:xfrm>
              <a:off x="6966000" y="7188120"/>
              <a:ext cx="6480" cy="1749600"/>
            </a:xfrm>
            <a:prstGeom prst="rect">
              <a:avLst/>
            </a:prstGeom>
            <a:blipFill rotWithShape="0">
              <a:blip r:embed="rId58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"/>
            <p:cNvSpPr/>
            <p:nvPr/>
          </p:nvSpPr>
          <p:spPr>
            <a:xfrm>
              <a:off x="6868800" y="89456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2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"/>
            <p:cNvSpPr/>
            <p:nvPr/>
          </p:nvSpPr>
          <p:spPr>
            <a:xfrm>
              <a:off x="6966000" y="8929800"/>
              <a:ext cx="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"/>
            <p:cNvSpPr/>
            <p:nvPr/>
          </p:nvSpPr>
          <p:spPr>
            <a:xfrm>
              <a:off x="7270920" y="7188120"/>
              <a:ext cx="6120" cy="1749600"/>
            </a:xfrm>
            <a:prstGeom prst="rect">
              <a:avLst/>
            </a:prstGeom>
            <a:blipFill rotWithShape="0">
              <a:blip r:embed="rId59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"/>
            <p:cNvSpPr/>
            <p:nvPr/>
          </p:nvSpPr>
          <p:spPr>
            <a:xfrm>
              <a:off x="7173720" y="89456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2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"/>
            <p:cNvSpPr/>
            <p:nvPr/>
          </p:nvSpPr>
          <p:spPr>
            <a:xfrm>
              <a:off x="7270920" y="8929800"/>
              <a:ext cx="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"/>
            <p:cNvSpPr/>
            <p:nvPr/>
          </p:nvSpPr>
          <p:spPr>
            <a:xfrm>
              <a:off x="7567560" y="7188120"/>
              <a:ext cx="7920" cy="1749600"/>
            </a:xfrm>
            <a:prstGeom prst="rect">
              <a:avLst/>
            </a:prstGeom>
            <a:blipFill rotWithShape="0">
              <a:blip r:embed="rId6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"/>
            <p:cNvSpPr/>
            <p:nvPr/>
          </p:nvSpPr>
          <p:spPr>
            <a:xfrm>
              <a:off x="7472160" y="89456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3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"/>
            <p:cNvSpPr/>
            <p:nvPr/>
          </p:nvSpPr>
          <p:spPr>
            <a:xfrm>
              <a:off x="7567560" y="8929800"/>
              <a:ext cx="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"/>
            <p:cNvSpPr/>
            <p:nvPr/>
          </p:nvSpPr>
          <p:spPr>
            <a:xfrm>
              <a:off x="7873920" y="7188120"/>
              <a:ext cx="6480" cy="1749600"/>
            </a:xfrm>
            <a:prstGeom prst="rect">
              <a:avLst/>
            </a:prstGeom>
            <a:blipFill rotWithShape="0">
              <a:blip r:embed="rId6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"/>
            <p:cNvSpPr/>
            <p:nvPr/>
          </p:nvSpPr>
          <p:spPr>
            <a:xfrm>
              <a:off x="7776720" y="89456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3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"/>
            <p:cNvSpPr/>
            <p:nvPr/>
          </p:nvSpPr>
          <p:spPr>
            <a:xfrm>
              <a:off x="7873920" y="8929800"/>
              <a:ext cx="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"/>
            <p:cNvSpPr/>
            <p:nvPr/>
          </p:nvSpPr>
          <p:spPr>
            <a:xfrm>
              <a:off x="8178840" y="7188120"/>
              <a:ext cx="6480" cy="1749600"/>
            </a:xfrm>
            <a:prstGeom prst="rect">
              <a:avLst/>
            </a:prstGeom>
            <a:blipFill rotWithShape="0">
              <a:blip r:embed="rId6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"/>
            <p:cNvSpPr/>
            <p:nvPr/>
          </p:nvSpPr>
          <p:spPr>
            <a:xfrm>
              <a:off x="8081640" y="89456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4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"/>
            <p:cNvSpPr/>
            <p:nvPr/>
          </p:nvSpPr>
          <p:spPr>
            <a:xfrm>
              <a:off x="8178840" y="8929800"/>
              <a:ext cx="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"/>
            <p:cNvSpPr/>
            <p:nvPr/>
          </p:nvSpPr>
          <p:spPr>
            <a:xfrm>
              <a:off x="8475840" y="7188120"/>
              <a:ext cx="7920" cy="1749600"/>
            </a:xfrm>
            <a:prstGeom prst="rect">
              <a:avLst/>
            </a:prstGeom>
            <a:blipFill rotWithShape="0">
              <a:blip r:embed="rId6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"/>
            <p:cNvSpPr/>
            <p:nvPr/>
          </p:nvSpPr>
          <p:spPr>
            <a:xfrm>
              <a:off x="8378640" y="89456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4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"/>
            <p:cNvSpPr/>
            <p:nvPr/>
          </p:nvSpPr>
          <p:spPr>
            <a:xfrm>
              <a:off x="8475840" y="8929800"/>
              <a:ext cx="0" cy="1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"/>
            <p:cNvSpPr/>
            <p:nvPr/>
          </p:nvSpPr>
          <p:spPr>
            <a:xfrm>
              <a:off x="5761080" y="8037360"/>
              <a:ext cx="2722680" cy="6480"/>
            </a:xfrm>
            <a:prstGeom prst="rect">
              <a:avLst/>
            </a:prstGeom>
            <a:blipFill rotWithShape="0">
              <a:blip r:embed="rId64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"/>
            <p:cNvSpPr/>
            <p:nvPr/>
          </p:nvSpPr>
          <p:spPr>
            <a:xfrm flipH="1">
              <a:off x="5745240" y="8037360"/>
              <a:ext cx="15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"/>
            <p:cNvSpPr/>
            <p:nvPr/>
          </p:nvSpPr>
          <p:spPr>
            <a:xfrm>
              <a:off x="5761080" y="8894880"/>
              <a:ext cx="2722680" cy="6120"/>
            </a:xfrm>
            <a:prstGeom prst="rect">
              <a:avLst/>
            </a:prstGeom>
            <a:blipFill rotWithShape="0">
              <a:blip r:embed="rId65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"/>
            <p:cNvSpPr/>
            <p:nvPr/>
          </p:nvSpPr>
          <p:spPr>
            <a:xfrm flipH="1">
              <a:off x="5745240" y="8894880"/>
              <a:ext cx="15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6" name=""/>
          <p:cNvGrpSpPr/>
          <p:nvPr/>
        </p:nvGrpSpPr>
        <p:grpSpPr>
          <a:xfrm>
            <a:off x="5189040" y="7170840"/>
            <a:ext cx="535320" cy="1781280"/>
            <a:chOff x="5189040" y="7170840"/>
            <a:chExt cx="535320" cy="1781280"/>
          </a:xfrm>
        </p:grpSpPr>
        <p:sp>
          <p:nvSpPr>
            <p:cNvPr id="667" name=""/>
            <p:cNvSpPr/>
            <p:nvPr/>
          </p:nvSpPr>
          <p:spPr>
            <a:xfrm>
              <a:off x="5481720" y="718812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"/>
            <p:cNvSpPr/>
            <p:nvPr/>
          </p:nvSpPr>
          <p:spPr>
            <a:xfrm>
              <a:off x="5488200" y="7324560"/>
              <a:ext cx="25200" cy="447840"/>
            </a:xfrm>
            <a:custGeom>
              <a:avLst/>
              <a:gdLst/>
              <a:ahLst/>
              <a:rect l="l" t="t" r="r" b="b"/>
              <a:pathLst>
                <a:path w="34" h="564">
                  <a:moveTo>
                    <a:pt x="34" y="0"/>
                  </a:moveTo>
                  <a:lnTo>
                    <a:pt x="2" y="0"/>
                  </a:lnTo>
                  <a:lnTo>
                    <a:pt x="0" y="564"/>
                  </a:lnTo>
                  <a:lnTo>
                    <a:pt x="32" y="5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"/>
            <p:cNvSpPr/>
            <p:nvPr/>
          </p:nvSpPr>
          <p:spPr>
            <a:xfrm>
              <a:off x="5461200" y="7764480"/>
              <a:ext cx="25200" cy="111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"/>
            <p:cNvSpPr/>
            <p:nvPr/>
          </p:nvSpPr>
          <p:spPr>
            <a:xfrm>
              <a:off x="5484960" y="7859520"/>
              <a:ext cx="28440" cy="481320"/>
            </a:xfrm>
            <a:custGeom>
              <a:avLst/>
              <a:gdLst/>
              <a:ahLst/>
              <a:rect l="l" t="t" r="r" b="b"/>
              <a:pathLst>
                <a:path w="35" h="607">
                  <a:moveTo>
                    <a:pt x="32" y="0"/>
                  </a:moveTo>
                  <a:lnTo>
                    <a:pt x="0" y="0"/>
                  </a:lnTo>
                  <a:lnTo>
                    <a:pt x="3" y="607"/>
                  </a:lnTo>
                  <a:lnTo>
                    <a:pt x="35" y="607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"/>
            <p:cNvSpPr/>
            <p:nvPr/>
          </p:nvSpPr>
          <p:spPr>
            <a:xfrm>
              <a:off x="5462640" y="8354880"/>
              <a:ext cx="27000" cy="427320"/>
            </a:xfrm>
            <a:custGeom>
              <a:avLst/>
              <a:gdLst/>
              <a:ahLst/>
              <a:rect l="l" t="t" r="r" b="b"/>
              <a:pathLst>
                <a:path w="35" h="538">
                  <a:moveTo>
                    <a:pt x="32" y="0"/>
                  </a:moveTo>
                  <a:lnTo>
                    <a:pt x="0" y="0"/>
                  </a:lnTo>
                  <a:lnTo>
                    <a:pt x="3" y="538"/>
                  </a:lnTo>
                  <a:lnTo>
                    <a:pt x="35" y="538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"/>
            <p:cNvSpPr/>
            <p:nvPr/>
          </p:nvSpPr>
          <p:spPr>
            <a:xfrm>
              <a:off x="5481720" y="880092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"/>
            <p:cNvSpPr/>
            <p:nvPr/>
          </p:nvSpPr>
          <p:spPr>
            <a:xfrm rot="16200000">
              <a:off x="5344920" y="74779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g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"/>
            <p:cNvSpPr/>
            <p:nvPr/>
          </p:nvSpPr>
          <p:spPr>
            <a:xfrm rot="16200000">
              <a:off x="5330880" y="7754760"/>
              <a:ext cx="14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r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"/>
            <p:cNvSpPr/>
            <p:nvPr/>
          </p:nvSpPr>
          <p:spPr>
            <a:xfrm rot="16200000">
              <a:off x="5360400" y="8025840"/>
              <a:ext cx="13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"/>
            <p:cNvSpPr/>
            <p:nvPr/>
          </p:nvSpPr>
          <p:spPr>
            <a:xfrm rot="16200000">
              <a:off x="5328360" y="8505000"/>
              <a:ext cx="16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env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"/>
            <p:cNvSpPr/>
            <p:nvPr/>
          </p:nvSpPr>
          <p:spPr>
            <a:xfrm>
              <a:off x="5189040" y="717084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"/>
            <p:cNvSpPr/>
            <p:nvPr/>
          </p:nvSpPr>
          <p:spPr>
            <a:xfrm>
              <a:off x="5189040" y="881388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"/>
            <p:cNvSpPr/>
            <p:nvPr/>
          </p:nvSpPr>
          <p:spPr>
            <a:xfrm>
              <a:off x="5573520" y="80168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"/>
            <p:cNvSpPr/>
            <p:nvPr/>
          </p:nvSpPr>
          <p:spPr>
            <a:xfrm>
              <a:off x="5540760" y="8875800"/>
              <a:ext cx="18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1" name=""/>
          <p:cNvGrpSpPr/>
          <p:nvPr/>
        </p:nvGrpSpPr>
        <p:grpSpPr>
          <a:xfrm>
            <a:off x="1449360" y="10250280"/>
            <a:ext cx="2780280" cy="1837080"/>
            <a:chOff x="1449360" y="10250280"/>
            <a:chExt cx="2780280" cy="1837080"/>
          </a:xfrm>
        </p:grpSpPr>
        <p:sp>
          <p:nvSpPr>
            <p:cNvPr id="682" name=""/>
            <p:cNvSpPr/>
            <p:nvPr/>
          </p:nvSpPr>
          <p:spPr>
            <a:xfrm>
              <a:off x="3228840" y="105202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"/>
            <p:cNvSpPr/>
            <p:nvPr/>
          </p:nvSpPr>
          <p:spPr>
            <a:xfrm>
              <a:off x="3497400" y="11196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"/>
            <p:cNvSpPr/>
            <p:nvPr/>
          </p:nvSpPr>
          <p:spPr>
            <a:xfrm>
              <a:off x="2952720" y="11574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"/>
            <p:cNvSpPr/>
            <p:nvPr/>
          </p:nvSpPr>
          <p:spPr>
            <a:xfrm>
              <a:off x="3228840" y="11633040"/>
              <a:ext cx="6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"/>
            <p:cNvSpPr/>
            <p:nvPr/>
          </p:nvSpPr>
          <p:spPr>
            <a:xfrm>
              <a:off x="2981160" y="11625120"/>
              <a:ext cx="8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"/>
            <p:cNvSpPr/>
            <p:nvPr/>
          </p:nvSpPr>
          <p:spPr>
            <a:xfrm>
              <a:off x="2989440" y="116251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"/>
            <p:cNvSpPr/>
            <p:nvPr/>
          </p:nvSpPr>
          <p:spPr>
            <a:xfrm flipV="1">
              <a:off x="1689120" y="11887200"/>
              <a:ext cx="152280" cy="302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"/>
            <p:cNvSpPr/>
            <p:nvPr/>
          </p:nvSpPr>
          <p:spPr>
            <a:xfrm flipV="1">
              <a:off x="1841400" y="11568240"/>
              <a:ext cx="1416240" cy="31248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"/>
            <p:cNvSpPr/>
            <p:nvPr/>
          </p:nvSpPr>
          <p:spPr>
            <a:xfrm>
              <a:off x="3265560" y="11568240"/>
              <a:ext cx="61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"/>
            <p:cNvSpPr/>
            <p:nvPr/>
          </p:nvSpPr>
          <p:spPr>
            <a:xfrm flipV="1">
              <a:off x="3271680" y="11239560"/>
              <a:ext cx="44640" cy="79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"/>
            <p:cNvSpPr/>
            <p:nvPr/>
          </p:nvSpPr>
          <p:spPr>
            <a:xfrm flipV="1">
              <a:off x="3322800" y="11210760"/>
              <a:ext cx="137880" cy="288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"/>
            <p:cNvSpPr/>
            <p:nvPr/>
          </p:nvSpPr>
          <p:spPr>
            <a:xfrm flipV="1">
              <a:off x="3468600" y="11202840"/>
              <a:ext cx="14400" cy="792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"/>
            <p:cNvSpPr/>
            <p:nvPr/>
          </p:nvSpPr>
          <p:spPr>
            <a:xfrm flipV="1">
              <a:off x="3489480" y="11188440"/>
              <a:ext cx="66600" cy="140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"/>
            <p:cNvSpPr/>
            <p:nvPr/>
          </p:nvSpPr>
          <p:spPr>
            <a:xfrm flipV="1">
              <a:off x="3556080" y="11131200"/>
              <a:ext cx="253800" cy="572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"/>
            <p:cNvSpPr/>
            <p:nvPr/>
          </p:nvSpPr>
          <p:spPr>
            <a:xfrm flipV="1">
              <a:off x="1841400" y="10250280"/>
              <a:ext cx="101880" cy="2196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"/>
            <p:cNvSpPr/>
            <p:nvPr/>
          </p:nvSpPr>
          <p:spPr>
            <a:xfrm flipV="1">
              <a:off x="1689120" y="10272600"/>
              <a:ext cx="152280" cy="2880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"/>
            <p:cNvSpPr/>
            <p:nvPr/>
          </p:nvSpPr>
          <p:spPr>
            <a:xfrm>
              <a:off x="1521000" y="10461600"/>
              <a:ext cx="7920" cy="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"/>
            <p:cNvSpPr/>
            <p:nvPr/>
          </p:nvSpPr>
          <p:spPr>
            <a:xfrm>
              <a:off x="1467000" y="10253520"/>
              <a:ext cx="2717640" cy="17398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"/>
            <p:cNvSpPr/>
            <p:nvPr/>
          </p:nvSpPr>
          <p:spPr>
            <a:xfrm>
              <a:off x="1847880" y="10250640"/>
              <a:ext cx="7920" cy="1753920"/>
            </a:xfrm>
            <a:prstGeom prst="rect">
              <a:avLst/>
            </a:prstGeom>
            <a:blipFill rotWithShape="0">
              <a:blip r:embed="rId66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"/>
            <p:cNvSpPr/>
            <p:nvPr/>
          </p:nvSpPr>
          <p:spPr>
            <a:xfrm>
              <a:off x="1775160" y="1201104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"/>
            <p:cNvSpPr/>
            <p:nvPr/>
          </p:nvSpPr>
          <p:spPr>
            <a:xfrm>
              <a:off x="1847880" y="1199664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"/>
            <p:cNvSpPr/>
            <p:nvPr/>
          </p:nvSpPr>
          <p:spPr>
            <a:xfrm>
              <a:off x="2239920" y="10250640"/>
              <a:ext cx="7920" cy="1753920"/>
            </a:xfrm>
            <a:prstGeom prst="rect">
              <a:avLst/>
            </a:prstGeom>
            <a:blipFill rotWithShape="0">
              <a:blip r:embed="rId67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"/>
            <p:cNvSpPr/>
            <p:nvPr/>
          </p:nvSpPr>
          <p:spPr>
            <a:xfrm>
              <a:off x="2142720" y="120110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"/>
            <p:cNvSpPr/>
            <p:nvPr/>
          </p:nvSpPr>
          <p:spPr>
            <a:xfrm>
              <a:off x="2239920" y="1199664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"/>
            <p:cNvSpPr/>
            <p:nvPr/>
          </p:nvSpPr>
          <p:spPr>
            <a:xfrm>
              <a:off x="2625840" y="10250640"/>
              <a:ext cx="6120" cy="1753920"/>
            </a:xfrm>
            <a:prstGeom prst="rect">
              <a:avLst/>
            </a:prstGeom>
            <a:blipFill rotWithShape="0">
              <a:blip r:embed="rId68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"/>
            <p:cNvSpPr/>
            <p:nvPr/>
          </p:nvSpPr>
          <p:spPr>
            <a:xfrm>
              <a:off x="2528640" y="120110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"/>
            <p:cNvSpPr/>
            <p:nvPr/>
          </p:nvSpPr>
          <p:spPr>
            <a:xfrm>
              <a:off x="2625840" y="1199664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"/>
            <p:cNvSpPr/>
            <p:nvPr/>
          </p:nvSpPr>
          <p:spPr>
            <a:xfrm>
              <a:off x="3017880" y="10250640"/>
              <a:ext cx="7920" cy="1753920"/>
            </a:xfrm>
            <a:prstGeom prst="rect">
              <a:avLst/>
            </a:prstGeom>
            <a:blipFill rotWithShape="0">
              <a:blip r:embed="rId69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"/>
            <p:cNvSpPr/>
            <p:nvPr/>
          </p:nvSpPr>
          <p:spPr>
            <a:xfrm>
              <a:off x="2920680" y="120110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2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"/>
            <p:cNvSpPr/>
            <p:nvPr/>
          </p:nvSpPr>
          <p:spPr>
            <a:xfrm>
              <a:off x="3017880" y="1199664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"/>
            <p:cNvSpPr/>
            <p:nvPr/>
          </p:nvSpPr>
          <p:spPr>
            <a:xfrm>
              <a:off x="3403440" y="10250640"/>
              <a:ext cx="6480" cy="1753920"/>
            </a:xfrm>
            <a:prstGeom prst="rect">
              <a:avLst/>
            </a:prstGeom>
            <a:blipFill rotWithShape="0">
              <a:blip r:embed="rId7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"/>
            <p:cNvSpPr/>
            <p:nvPr/>
          </p:nvSpPr>
          <p:spPr>
            <a:xfrm>
              <a:off x="3306600" y="120110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2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"/>
            <p:cNvSpPr/>
            <p:nvPr/>
          </p:nvSpPr>
          <p:spPr>
            <a:xfrm>
              <a:off x="3403440" y="1199664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"/>
            <p:cNvSpPr/>
            <p:nvPr/>
          </p:nvSpPr>
          <p:spPr>
            <a:xfrm>
              <a:off x="3795840" y="10250640"/>
              <a:ext cx="6120" cy="1753920"/>
            </a:xfrm>
            <a:prstGeom prst="rect">
              <a:avLst/>
            </a:prstGeom>
            <a:blipFill rotWithShape="0">
              <a:blip r:embed="rId7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"/>
            <p:cNvSpPr/>
            <p:nvPr/>
          </p:nvSpPr>
          <p:spPr>
            <a:xfrm>
              <a:off x="3698640" y="120110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3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"/>
            <p:cNvSpPr/>
            <p:nvPr/>
          </p:nvSpPr>
          <p:spPr>
            <a:xfrm>
              <a:off x="3795840" y="1199664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"/>
            <p:cNvSpPr/>
            <p:nvPr/>
          </p:nvSpPr>
          <p:spPr>
            <a:xfrm>
              <a:off x="4179960" y="10250640"/>
              <a:ext cx="7920" cy="1753920"/>
            </a:xfrm>
            <a:prstGeom prst="rect">
              <a:avLst/>
            </a:prstGeom>
            <a:blipFill rotWithShape="0">
              <a:blip r:embed="rId7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"/>
            <p:cNvSpPr/>
            <p:nvPr/>
          </p:nvSpPr>
          <p:spPr>
            <a:xfrm>
              <a:off x="4082760" y="1201104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3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"/>
            <p:cNvSpPr/>
            <p:nvPr/>
          </p:nvSpPr>
          <p:spPr>
            <a:xfrm>
              <a:off x="4179960" y="11996640"/>
              <a:ext cx="0" cy="14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"/>
            <p:cNvSpPr/>
            <p:nvPr/>
          </p:nvSpPr>
          <p:spPr>
            <a:xfrm>
              <a:off x="1463760" y="11101320"/>
              <a:ext cx="2724120" cy="7920"/>
            </a:xfrm>
            <a:prstGeom prst="rect">
              <a:avLst/>
            </a:prstGeom>
            <a:blipFill rotWithShape="0">
              <a:blip r:embed="rId7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"/>
            <p:cNvSpPr/>
            <p:nvPr/>
          </p:nvSpPr>
          <p:spPr>
            <a:xfrm flipH="1">
              <a:off x="1449360" y="11101320"/>
              <a:ext cx="14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"/>
            <p:cNvSpPr/>
            <p:nvPr/>
          </p:nvSpPr>
          <p:spPr>
            <a:xfrm>
              <a:off x="1463760" y="11960280"/>
              <a:ext cx="2724120" cy="7920"/>
            </a:xfrm>
            <a:prstGeom prst="rect">
              <a:avLst/>
            </a:prstGeom>
            <a:blipFill rotWithShape="0">
              <a:blip r:embed="rId74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"/>
            <p:cNvSpPr/>
            <p:nvPr/>
          </p:nvSpPr>
          <p:spPr>
            <a:xfrm flipH="1">
              <a:off x="1449360" y="11960280"/>
              <a:ext cx="14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5" name=""/>
          <p:cNvGrpSpPr/>
          <p:nvPr/>
        </p:nvGrpSpPr>
        <p:grpSpPr>
          <a:xfrm>
            <a:off x="898200" y="10233000"/>
            <a:ext cx="535320" cy="1781280"/>
            <a:chOff x="898200" y="10233000"/>
            <a:chExt cx="535320" cy="1781280"/>
          </a:xfrm>
        </p:grpSpPr>
        <p:sp>
          <p:nvSpPr>
            <p:cNvPr id="726" name=""/>
            <p:cNvSpPr/>
            <p:nvPr/>
          </p:nvSpPr>
          <p:spPr>
            <a:xfrm>
              <a:off x="1190880" y="1025028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"/>
            <p:cNvSpPr/>
            <p:nvPr/>
          </p:nvSpPr>
          <p:spPr>
            <a:xfrm>
              <a:off x="1197360" y="10386720"/>
              <a:ext cx="25200" cy="447840"/>
            </a:xfrm>
            <a:custGeom>
              <a:avLst/>
              <a:gdLst/>
              <a:ahLst/>
              <a:rect l="l" t="t" r="r" b="b"/>
              <a:pathLst>
                <a:path w="34" h="564">
                  <a:moveTo>
                    <a:pt x="34" y="0"/>
                  </a:moveTo>
                  <a:lnTo>
                    <a:pt x="2" y="0"/>
                  </a:lnTo>
                  <a:lnTo>
                    <a:pt x="0" y="564"/>
                  </a:lnTo>
                  <a:lnTo>
                    <a:pt x="32" y="5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"/>
            <p:cNvSpPr/>
            <p:nvPr/>
          </p:nvSpPr>
          <p:spPr>
            <a:xfrm>
              <a:off x="1170360" y="10826640"/>
              <a:ext cx="25200" cy="111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"/>
            <p:cNvSpPr/>
            <p:nvPr/>
          </p:nvSpPr>
          <p:spPr>
            <a:xfrm>
              <a:off x="1194120" y="10921680"/>
              <a:ext cx="28440" cy="481320"/>
            </a:xfrm>
            <a:custGeom>
              <a:avLst/>
              <a:gdLst/>
              <a:ahLst/>
              <a:rect l="l" t="t" r="r" b="b"/>
              <a:pathLst>
                <a:path w="35" h="607">
                  <a:moveTo>
                    <a:pt x="32" y="0"/>
                  </a:moveTo>
                  <a:lnTo>
                    <a:pt x="0" y="0"/>
                  </a:lnTo>
                  <a:lnTo>
                    <a:pt x="3" y="607"/>
                  </a:lnTo>
                  <a:lnTo>
                    <a:pt x="35" y="607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"/>
            <p:cNvSpPr/>
            <p:nvPr/>
          </p:nvSpPr>
          <p:spPr>
            <a:xfrm>
              <a:off x="1171800" y="11417040"/>
              <a:ext cx="27000" cy="427320"/>
            </a:xfrm>
            <a:custGeom>
              <a:avLst/>
              <a:gdLst/>
              <a:ahLst/>
              <a:rect l="l" t="t" r="r" b="b"/>
              <a:pathLst>
                <a:path w="35" h="538">
                  <a:moveTo>
                    <a:pt x="32" y="0"/>
                  </a:moveTo>
                  <a:lnTo>
                    <a:pt x="0" y="0"/>
                  </a:lnTo>
                  <a:lnTo>
                    <a:pt x="3" y="538"/>
                  </a:lnTo>
                  <a:lnTo>
                    <a:pt x="35" y="538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"/>
            <p:cNvSpPr/>
            <p:nvPr/>
          </p:nvSpPr>
          <p:spPr>
            <a:xfrm>
              <a:off x="1190880" y="11863080"/>
              <a:ext cx="3816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"/>
            <p:cNvSpPr/>
            <p:nvPr/>
          </p:nvSpPr>
          <p:spPr>
            <a:xfrm rot="16200000">
              <a:off x="1054080" y="105400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g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"/>
            <p:cNvSpPr/>
            <p:nvPr/>
          </p:nvSpPr>
          <p:spPr>
            <a:xfrm rot="16200000">
              <a:off x="1040040" y="10816920"/>
              <a:ext cx="14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r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"/>
            <p:cNvSpPr/>
            <p:nvPr/>
          </p:nvSpPr>
          <p:spPr>
            <a:xfrm rot="16200000">
              <a:off x="1069560" y="11088000"/>
              <a:ext cx="13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"/>
            <p:cNvSpPr/>
            <p:nvPr/>
          </p:nvSpPr>
          <p:spPr>
            <a:xfrm rot="16200000">
              <a:off x="1037520" y="11567160"/>
              <a:ext cx="16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env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"/>
            <p:cNvSpPr/>
            <p:nvPr/>
          </p:nvSpPr>
          <p:spPr>
            <a:xfrm>
              <a:off x="898200" y="1023300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"/>
            <p:cNvSpPr/>
            <p:nvPr/>
          </p:nvSpPr>
          <p:spPr>
            <a:xfrm>
              <a:off x="898200" y="11876040"/>
              <a:ext cx="26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TR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"/>
            <p:cNvSpPr/>
            <p:nvPr/>
          </p:nvSpPr>
          <p:spPr>
            <a:xfrm>
              <a:off x="1282680" y="11079000"/>
              <a:ext cx="146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5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"/>
            <p:cNvSpPr/>
            <p:nvPr/>
          </p:nvSpPr>
          <p:spPr>
            <a:xfrm>
              <a:off x="1249920" y="11937960"/>
              <a:ext cx="18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onaco"/>
                </a:rPr>
                <a:t>10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0" name=""/>
          <p:cNvSpPr/>
          <p:nvPr/>
        </p:nvSpPr>
        <p:spPr>
          <a:xfrm>
            <a:off x="1791000" y="5935680"/>
            <a:ext cx="22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"/>
          <p:cNvSpPr/>
          <p:nvPr/>
        </p:nvSpPr>
        <p:spPr>
          <a:xfrm>
            <a:off x="2437200" y="12092040"/>
            <a:ext cx="25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2" name=""/>
          <p:cNvSpPr/>
          <p:nvPr/>
        </p:nvSpPr>
        <p:spPr>
          <a:xfrm>
            <a:off x="539640" y="325440"/>
            <a:ext cx="844560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Laufer et al. additional fi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ustell matrix comparisons of the seven HERV-W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env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loci identified as transcriptionally active in human PBMC in this study. The HERV-W reference sequence (y-axis) consists of LTR17 and HERV17 sequences as previously reported in Repbase (http://girinst.org/repbase/update/). The position of genes and LTRs are indicated for the reference sequence. HERV-W loci (x-axis) are designated according to their chromosomal location. The range of nucleotides on the respective chromosome analyzed by Pustell matrix comparisons is indicated. 5 out of 7 HERV-W loci are in antisense orientation, depicted by blue lines. Parameter settings were: Window size = 30 nt; Min.% Score = 55; Hash value = 6; Jump = 1; Strands = both. Therefore, each stretch in one sequence that is at least 55% similar in a 30 nt window to the other sequence is marked by a dot, resulting in a line if similarities extend over longer sequence stretches. A three-frame translation of the corresponding sense-strand is shown below each matrix comparis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* ORF for syncytin-1 in the 7q21.2 HERV-W proviru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** ORF for a N-terminally truncated 475 amino acid HERV-W Env protein in the Xq22.3 HERV-W element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22T06:42:19Z</dcterms:created>
  <dc:creator>Virologie</dc:creator>
  <dc:description/>
  <dc:language>en-US</dc:language>
  <cp:lastModifiedBy>Virologie</cp:lastModifiedBy>
  <dcterms:modified xsi:type="dcterms:W3CDTF">2009-03-24T07:24:45Z</dcterms:modified>
  <cp:revision>45</cp:revision>
  <dc:subject/>
  <dc:title>Folie 1</dc:title>
</cp:coreProperties>
</file>